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0" r:id="rId2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724"/>
    <p:restoredTop sz="96801"/>
  </p:normalViewPr>
  <p:slideViewPr>
    <p:cSldViewPr snapToGrid="0" snapToObjects="1">
      <p:cViewPr varScale="1">
        <p:scale>
          <a:sx n="88" d="100"/>
          <a:sy n="88" d="100"/>
        </p:scale>
        <p:origin x="-3234" y="-10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3_2">
  <dgm:title val=""/>
  <dgm:desc val=""/>
  <dgm:catLst>
    <dgm:cat type="accent3" pri="11200"/>
  </dgm:catLst>
  <dgm:styleLbl name="node0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node1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3"/>
    </dgm:fillClrLst>
    <dgm:linClrLst meth="repeat">
      <a:schemeClr val="accent3"/>
    </dgm:linClrLst>
    <dgm:effectClrLst/>
    <dgm:txLinClrLst/>
    <dgm:txFillClrLst/>
    <dgm:txEffectClrLst/>
  </dgm:styleLbl>
  <dgm:styleLbl name="lnNode1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3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3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3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3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3">
        <a:tint val="60000"/>
      </a:schemeClr>
    </dgm:fillClrLst>
    <dgm:linClrLst meth="repeat">
      <a:schemeClr val="accent3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3">
        <a:tint val="60000"/>
      </a:schemeClr>
    </dgm:fillClrLst>
    <dgm:linClrLst meth="repeat">
      <a:schemeClr val="accent3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3">
        <a:tint val="60000"/>
      </a:schemeClr>
    </dgm:fillClrLst>
    <dgm:linClrLst meth="repeat">
      <a:schemeClr val="accent3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3"/>
    </dgm:fillClrLst>
    <dgm:linClrLst meth="repeat">
      <a:schemeClr val="accent3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3"/>
    </dgm:fillClrLst>
    <dgm:linClrLst meth="repeat">
      <a:schemeClr val="accent3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3">
        <a:tint val="60000"/>
      </a:schemeClr>
    </dgm:fillClrLst>
    <dgm:linClrLst meth="repeat">
      <a:schemeClr val="accent3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3"/>
    </dgm:fillClrLst>
    <dgm:linClrLst meth="repeat">
      <a:schemeClr val="accent3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3"/>
    </dgm:fillClrLst>
    <dgm:linClrLst meth="repeat">
      <a:schemeClr val="accent3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3"/>
    </dgm:fillClrLst>
    <dgm:linClrLst meth="repeat">
      <a:schemeClr val="accent3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3"/>
    </dgm:fillClrLst>
    <dgm:linClrLst meth="repeat">
      <a:schemeClr val="accent3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3"/>
    </dgm:fillClrLst>
    <dgm:linClrLst meth="repeat">
      <a:schemeClr val="accent3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3"/>
    </dgm:fillClrLst>
    <dgm:linClrLst meth="repeat">
      <a:schemeClr val="accent3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3"/>
    </dgm:fillClrLst>
    <dgm:linClrLst meth="repeat">
      <a:schemeClr val="accent3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3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3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3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3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3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3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3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3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3">
        <a:alpha val="90000"/>
        <a:tint val="40000"/>
      </a:schemeClr>
    </dgm:fillClrLst>
    <dgm:linClrLst meth="repeat">
      <a:schemeClr val="accent3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3">
        <a:alpha val="90000"/>
        <a:tint val="40000"/>
      </a:schemeClr>
    </dgm:fillClrLst>
    <dgm:linClrLst meth="repeat">
      <a:schemeClr val="accent3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3">
        <a:alpha val="90000"/>
        <a:tint val="40000"/>
      </a:schemeClr>
    </dgm:fillClrLst>
    <dgm:linClrLst meth="repeat">
      <a:schemeClr val="accent3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3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3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3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3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3">
        <a:tint val="40000"/>
      </a:schemeClr>
    </dgm:fillClrLst>
    <dgm:linClrLst meth="repeat">
      <a:schemeClr val="accent3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3">
        <a:shade val="80000"/>
      </a:schemeClr>
    </dgm:fillClrLst>
    <dgm:linClrLst meth="repeat">
      <a:schemeClr val="accent3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3">
        <a:tint val="50000"/>
        <a:alpha val="40000"/>
      </a:schemeClr>
    </dgm:fillClrLst>
    <dgm:linClrLst meth="repeat">
      <a:schemeClr val="accent3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3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E18B77DE-4383-C94D-9D2B-227A1F65E237}" type="doc">
      <dgm:prSet loTypeId="urn:microsoft.com/office/officeart/2005/8/layout/hierarchy1" loCatId="" qsTypeId="urn:microsoft.com/office/officeart/2005/8/quickstyle/simple1" qsCatId="simple" csTypeId="urn:microsoft.com/office/officeart/2005/8/colors/accent3_2" csCatId="accent3" phldr="1"/>
      <dgm:spPr/>
      <dgm:t>
        <a:bodyPr/>
        <a:lstStyle/>
        <a:p>
          <a:endParaRPr lang="en-US"/>
        </a:p>
      </dgm:t>
    </dgm:pt>
    <dgm:pt modelId="{D90B79BB-3114-BB4E-A83D-A3C6F5D84DEC}">
      <dgm:prSet phldrT="[Text]" custT="1"/>
      <dgm:spPr/>
      <dgm:t>
        <a:bodyPr/>
        <a:lstStyle/>
        <a:p>
          <a:r>
            <a:rPr lang="en-US" sz="1200" b="0" i="0" u="none" dirty="0">
              <a:latin typeface="Times New Roman" panose="02020603050405020304" pitchFamily="18" charset="0"/>
              <a:cs typeface="Times New Roman" panose="02020603050405020304" pitchFamily="18" charset="0"/>
            </a:rPr>
            <a:t>response to stimulus</a:t>
          </a:r>
          <a:endParaRPr lang="en-US" sz="1200" b="0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91D01A44-16D1-4641-89FB-1B2E6C588F67}" type="parTrans" cxnId="{A09910D1-4829-C145-801E-A2F18A600129}">
      <dgm:prSet/>
      <dgm:spPr/>
      <dgm:t>
        <a:bodyPr/>
        <a:lstStyle/>
        <a:p>
          <a:endParaRPr lang="en-US" sz="1200" b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0500F052-EDC0-E543-AC5F-A67F26188B5B}" type="sibTrans" cxnId="{A09910D1-4829-C145-801E-A2F18A600129}">
      <dgm:prSet/>
      <dgm:spPr/>
      <dgm:t>
        <a:bodyPr/>
        <a:lstStyle/>
        <a:p>
          <a:endParaRPr lang="en-US" sz="1200" b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E3CDEEEF-BDCB-AA46-8517-2725DFE0F661}">
      <dgm:prSet custT="1"/>
      <dgm:spPr/>
      <dgm:t>
        <a:bodyPr/>
        <a:lstStyle/>
        <a:p>
          <a:r>
            <a:rPr lang="en-US" sz="1200" b="0" dirty="0">
              <a:latin typeface="Times New Roman" panose="02020603050405020304" pitchFamily="18" charset="0"/>
              <a:cs typeface="Times New Roman" panose="02020603050405020304" pitchFamily="18" charset="0"/>
            </a:rPr>
            <a:t>response to endogenous stimulus</a:t>
          </a:r>
        </a:p>
      </dgm:t>
    </dgm:pt>
    <dgm:pt modelId="{90AB2523-EC98-3644-B888-3ECEB6853A1D}" type="parTrans" cxnId="{DBC2C0E1-AA19-894F-8D0A-062D676476FA}">
      <dgm:prSet/>
      <dgm:spPr/>
      <dgm:t>
        <a:bodyPr/>
        <a:lstStyle/>
        <a:p>
          <a:endParaRPr lang="en-US" sz="1200" b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A5428490-24A4-3149-8430-CD1166B86A8F}" type="sibTrans" cxnId="{DBC2C0E1-AA19-894F-8D0A-062D676476FA}">
      <dgm:prSet/>
      <dgm:spPr/>
      <dgm:t>
        <a:bodyPr/>
        <a:lstStyle/>
        <a:p>
          <a:endParaRPr lang="en-US" sz="1200" b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55A62BB0-0C85-2548-A2AC-F480529B3235}">
      <dgm:prSet custT="1"/>
      <dgm:spPr/>
      <dgm:t>
        <a:bodyPr/>
        <a:lstStyle/>
        <a:p>
          <a:r>
            <a:rPr lang="en-US" sz="1200" b="0" dirty="0">
              <a:latin typeface="Times New Roman" panose="02020603050405020304" pitchFamily="18" charset="0"/>
              <a:cs typeface="Times New Roman" panose="02020603050405020304" pitchFamily="18" charset="0"/>
            </a:rPr>
            <a:t>response to stress</a:t>
          </a:r>
        </a:p>
      </dgm:t>
    </dgm:pt>
    <dgm:pt modelId="{E4903445-E5D7-3E46-9B10-98C4A3BD2C1D}" type="parTrans" cxnId="{0D9DAA66-6C5E-2E47-80A0-79A3D9E93EC5}">
      <dgm:prSet/>
      <dgm:spPr/>
      <dgm:t>
        <a:bodyPr/>
        <a:lstStyle/>
        <a:p>
          <a:endParaRPr lang="en-US" sz="1200" b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D6E4BD27-9EAD-2A4C-AC65-44334DB70060}" type="sibTrans" cxnId="{0D9DAA66-6C5E-2E47-80A0-79A3D9E93EC5}">
      <dgm:prSet/>
      <dgm:spPr/>
      <dgm:t>
        <a:bodyPr/>
        <a:lstStyle/>
        <a:p>
          <a:endParaRPr lang="en-US" sz="1200" b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EC785628-EFE1-3241-B928-71BA71F4F978}">
      <dgm:prSet custT="1"/>
      <dgm:spPr/>
      <dgm:t>
        <a:bodyPr/>
        <a:lstStyle/>
        <a:p>
          <a:r>
            <a:rPr lang="en-US" sz="1200" b="0" dirty="0">
              <a:latin typeface="Times New Roman" panose="02020603050405020304" pitchFamily="18" charset="0"/>
              <a:cs typeface="Times New Roman" panose="02020603050405020304" pitchFamily="18" charset="0"/>
            </a:rPr>
            <a:t>response to external stimulus</a:t>
          </a:r>
        </a:p>
      </dgm:t>
    </dgm:pt>
    <dgm:pt modelId="{567493BF-6920-5A4C-BFC2-3B55EF0D722C}" type="sibTrans" cxnId="{3782A76E-9649-354E-A285-A58B99F3FB59}">
      <dgm:prSet/>
      <dgm:spPr/>
      <dgm:t>
        <a:bodyPr/>
        <a:lstStyle/>
        <a:p>
          <a:endParaRPr lang="en-US" sz="1200" b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F6225075-1722-A24F-AC03-F5646CD5FF30}" type="parTrans" cxnId="{3782A76E-9649-354E-A285-A58B99F3FB59}">
      <dgm:prSet/>
      <dgm:spPr/>
      <dgm:t>
        <a:bodyPr/>
        <a:lstStyle/>
        <a:p>
          <a:endParaRPr lang="en-US" sz="1200" b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FFD1CA6F-1C56-F843-A4C7-0590026072B3}">
      <dgm:prSet custT="1"/>
      <dgm:spPr/>
      <dgm:t>
        <a:bodyPr/>
        <a:lstStyle/>
        <a:p>
          <a:r>
            <a:rPr lang="en-US" sz="1200" b="0" dirty="0">
              <a:latin typeface="Times New Roman" panose="02020603050405020304" pitchFamily="18" charset="0"/>
              <a:cs typeface="Times New Roman" panose="02020603050405020304" pitchFamily="18" charset="0"/>
            </a:rPr>
            <a:t>response to other organism</a:t>
          </a:r>
        </a:p>
      </dgm:t>
    </dgm:pt>
    <dgm:pt modelId="{FB923C19-83B1-E243-AF56-C2785316ACE6}" type="parTrans" cxnId="{E972F09A-664D-E645-A786-BC34F2A58A23}">
      <dgm:prSet/>
      <dgm:spPr/>
      <dgm:t>
        <a:bodyPr/>
        <a:lstStyle/>
        <a:p>
          <a:endParaRPr lang="en-US" sz="1200" b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A053F64B-5220-3B42-AADD-7C2849B37549}" type="sibTrans" cxnId="{E972F09A-664D-E645-A786-BC34F2A58A23}">
      <dgm:prSet/>
      <dgm:spPr/>
      <dgm:t>
        <a:bodyPr/>
        <a:lstStyle/>
        <a:p>
          <a:endParaRPr lang="en-US" sz="1200" b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39B590C7-FE92-8844-9C15-BDADD53DB43C}">
      <dgm:prSet custT="1"/>
      <dgm:spPr/>
      <dgm:t>
        <a:bodyPr/>
        <a:lstStyle/>
        <a:p>
          <a:r>
            <a:rPr lang="en-US" sz="1200" b="0" dirty="0">
              <a:latin typeface="Times New Roman" panose="02020603050405020304" pitchFamily="18" charset="0"/>
              <a:cs typeface="Times New Roman" panose="02020603050405020304" pitchFamily="18" charset="0"/>
            </a:rPr>
            <a:t>Response to chemical</a:t>
          </a:r>
        </a:p>
      </dgm:t>
    </dgm:pt>
    <dgm:pt modelId="{4C4F30BB-D2EE-8846-81C0-8B43694EA471}" type="parTrans" cxnId="{3147213C-BB4E-8849-8A29-2DE4506FE663}">
      <dgm:prSet/>
      <dgm:spPr/>
      <dgm:t>
        <a:bodyPr/>
        <a:lstStyle/>
        <a:p>
          <a:endParaRPr lang="en-US" sz="1200" b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E580A5A5-9F94-3D4C-80E6-0153AB9A8787}" type="sibTrans" cxnId="{3147213C-BB4E-8849-8A29-2DE4506FE663}">
      <dgm:prSet/>
      <dgm:spPr/>
      <dgm:t>
        <a:bodyPr/>
        <a:lstStyle/>
        <a:p>
          <a:endParaRPr lang="en-US" sz="1200" b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95EBF237-1DF4-9947-96BC-268F799DAEBC}">
      <dgm:prSet custT="1"/>
      <dgm:spPr/>
      <dgm:t>
        <a:bodyPr/>
        <a:lstStyle/>
        <a:p>
          <a:r>
            <a:rPr lang="en-US" sz="1200" b="0">
              <a:latin typeface="Times New Roman" panose="02020603050405020304" pitchFamily="18" charset="0"/>
              <a:cs typeface="Times New Roman" panose="02020603050405020304" pitchFamily="18" charset="0"/>
            </a:rPr>
            <a:t>response to external biotic stimulus</a:t>
          </a:r>
        </a:p>
      </dgm:t>
    </dgm:pt>
    <dgm:pt modelId="{41E8D1A8-D995-F746-AFD5-1CF0A529B119}" type="parTrans" cxnId="{426E721D-3F6D-0542-B86E-4FEC053B116D}">
      <dgm:prSet/>
      <dgm:spPr/>
      <dgm:t>
        <a:bodyPr/>
        <a:lstStyle/>
        <a:p>
          <a:endParaRPr lang="en-US" sz="1200" b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FBACA171-90C6-434E-9596-3E5E4CEB7861}" type="sibTrans" cxnId="{426E721D-3F6D-0542-B86E-4FEC053B116D}">
      <dgm:prSet/>
      <dgm:spPr/>
      <dgm:t>
        <a:bodyPr/>
        <a:lstStyle/>
        <a:p>
          <a:endParaRPr lang="en-US" sz="1200" b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F7CD9937-968C-2C46-B6EA-ED36AA06E128}">
      <dgm:prSet custT="1"/>
      <dgm:spPr/>
      <dgm:t>
        <a:bodyPr/>
        <a:lstStyle/>
        <a:p>
          <a:r>
            <a:rPr lang="en-US" sz="1200" b="0" i="0" u="none">
              <a:latin typeface="Times New Roman" panose="02020603050405020304" pitchFamily="18" charset="0"/>
              <a:cs typeface="Times New Roman" panose="02020603050405020304" pitchFamily="18" charset="0"/>
            </a:rPr>
            <a:t>response to acid chemical</a:t>
          </a:r>
          <a:endParaRPr lang="en-US" sz="1200" b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C41C5276-EF16-B048-8C35-AAC745270F58}" type="parTrans" cxnId="{BCE0E3A7-72F8-AD47-8D52-962687408401}">
      <dgm:prSet/>
      <dgm:spPr/>
      <dgm:t>
        <a:bodyPr/>
        <a:lstStyle/>
        <a:p>
          <a:endParaRPr lang="en-US" sz="1200" b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691E1742-F259-5747-8CC3-3C131C33389E}" type="sibTrans" cxnId="{BCE0E3A7-72F8-AD47-8D52-962687408401}">
      <dgm:prSet/>
      <dgm:spPr/>
      <dgm:t>
        <a:bodyPr/>
        <a:lstStyle/>
        <a:p>
          <a:endParaRPr lang="en-US" sz="1200" b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3C5CCC3F-4310-854A-BDC4-202A114F19F2}">
      <dgm:prSet custT="1"/>
      <dgm:spPr/>
      <dgm:t>
        <a:bodyPr/>
        <a:lstStyle/>
        <a:p>
          <a:r>
            <a:rPr lang="en-US" sz="1200" b="0" i="0" u="none">
              <a:latin typeface="Times New Roman" panose="02020603050405020304" pitchFamily="18" charset="0"/>
              <a:cs typeface="Times New Roman" panose="02020603050405020304" pitchFamily="18" charset="0"/>
            </a:rPr>
            <a:t>response to organic substance</a:t>
          </a:r>
          <a:endParaRPr lang="en-US" sz="1200" b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BA5AD8F3-B568-9344-8CEE-0276BE38E893}" type="parTrans" cxnId="{65D5D749-E531-7642-81B0-01EAD748FE52}">
      <dgm:prSet/>
      <dgm:spPr/>
      <dgm:t>
        <a:bodyPr/>
        <a:lstStyle/>
        <a:p>
          <a:endParaRPr lang="en-US" sz="1200" b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F0AD0692-53BF-5240-AD82-3D14BAD0A43B}" type="sibTrans" cxnId="{65D5D749-E531-7642-81B0-01EAD748FE52}">
      <dgm:prSet/>
      <dgm:spPr/>
      <dgm:t>
        <a:bodyPr/>
        <a:lstStyle/>
        <a:p>
          <a:endParaRPr lang="en-US" sz="1200" b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12691330-6F94-7343-8F3E-5B2324E2325A}">
      <dgm:prSet custT="1"/>
      <dgm:spPr/>
      <dgm:t>
        <a:bodyPr/>
        <a:lstStyle/>
        <a:p>
          <a:r>
            <a:rPr lang="en-US" sz="1200" b="0" dirty="0">
              <a:latin typeface="Times New Roman" panose="02020603050405020304" pitchFamily="18" charset="0"/>
              <a:cs typeface="Times New Roman" panose="02020603050405020304" pitchFamily="18" charset="0"/>
            </a:rPr>
            <a:t>biological processes</a:t>
          </a:r>
        </a:p>
      </dgm:t>
    </dgm:pt>
    <dgm:pt modelId="{6AFAF9EE-83A7-FB45-A5C9-F7778FEB4DBB}" type="parTrans" cxnId="{7FC255D7-1805-1A40-9FCF-E1CBF9A05AE5}">
      <dgm:prSet/>
      <dgm:spPr/>
      <dgm:t>
        <a:bodyPr/>
        <a:lstStyle/>
        <a:p>
          <a:endParaRPr lang="en-US" sz="1200" b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3A6AB3D5-52F1-664C-9A72-844ADF974F81}" type="sibTrans" cxnId="{7FC255D7-1805-1A40-9FCF-E1CBF9A05AE5}">
      <dgm:prSet/>
      <dgm:spPr/>
      <dgm:t>
        <a:bodyPr/>
        <a:lstStyle/>
        <a:p>
          <a:endParaRPr lang="en-US" sz="1200" b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F95A066A-376B-0F44-829F-B3BB2C01B4EA}">
      <dgm:prSet custT="1"/>
      <dgm:spPr/>
      <dgm:t>
        <a:bodyPr/>
        <a:lstStyle/>
        <a:p>
          <a:r>
            <a:rPr lang="en-US" sz="1200" b="0" i="0" u="none" dirty="0">
              <a:latin typeface="Times New Roman" panose="02020603050405020304" pitchFamily="18" charset="0"/>
              <a:cs typeface="Times New Roman" panose="02020603050405020304" pitchFamily="18" charset="0"/>
            </a:rPr>
            <a:t>multi-organism process</a:t>
          </a:r>
          <a:endParaRPr lang="en-US" sz="1200" b="0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F162D4F8-1D1F-634D-A78A-C8110FDCA41A}" type="parTrans" cxnId="{41DC15F3-3257-C84F-9C10-A46A3431F564}">
      <dgm:prSet/>
      <dgm:spPr/>
      <dgm:t>
        <a:bodyPr/>
        <a:lstStyle/>
        <a:p>
          <a:endParaRPr lang="en-US" sz="1200" b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38AADBF0-3EFA-1541-8FFF-A07C0261A270}" type="sibTrans" cxnId="{41DC15F3-3257-C84F-9C10-A46A3431F564}">
      <dgm:prSet/>
      <dgm:spPr/>
      <dgm:t>
        <a:bodyPr/>
        <a:lstStyle/>
        <a:p>
          <a:endParaRPr lang="en-US" sz="1200" b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ABDA5E5B-712A-0A40-843E-90A4F93CC7DF}">
      <dgm:prSet custT="1"/>
      <dgm:spPr/>
      <dgm:t>
        <a:bodyPr/>
        <a:lstStyle/>
        <a:p>
          <a:r>
            <a:rPr lang="en-US" sz="1200" b="0" i="0" u="none">
              <a:latin typeface="Times New Roman" panose="02020603050405020304" pitchFamily="18" charset="0"/>
              <a:cs typeface="Times New Roman" panose="02020603050405020304" pitchFamily="18" charset="0"/>
            </a:rPr>
            <a:t>response to oxygen-containing compound</a:t>
          </a:r>
          <a:endParaRPr lang="en-US" sz="1200" b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7AC76103-7B93-A945-8E73-E7A35AF95F29}" type="parTrans" cxnId="{F7A67344-6889-5F47-9786-91EA865F4AB9}">
      <dgm:prSet/>
      <dgm:spPr/>
      <dgm:t>
        <a:bodyPr/>
        <a:lstStyle/>
        <a:p>
          <a:endParaRPr lang="en-US" sz="1200" b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191357D8-2D25-884C-8CCF-5A276820AA05}" type="sibTrans" cxnId="{F7A67344-6889-5F47-9786-91EA865F4AB9}">
      <dgm:prSet/>
      <dgm:spPr/>
      <dgm:t>
        <a:bodyPr/>
        <a:lstStyle/>
        <a:p>
          <a:endParaRPr lang="en-US" sz="1200" b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FE4C3C45-28F3-4E45-8295-0A78D0718B28}" type="pres">
      <dgm:prSet presAssocID="{E18B77DE-4383-C94D-9D2B-227A1F65E237}" presName="hierChild1" presStyleCnt="0">
        <dgm:presLayoutVars>
          <dgm:chPref val="1"/>
          <dgm:dir/>
          <dgm:animOne val="branch"/>
          <dgm:animLvl val="lvl"/>
          <dgm:resizeHandles/>
        </dgm:presLayoutVars>
      </dgm:prSet>
      <dgm:spPr/>
      <dgm:t>
        <a:bodyPr/>
        <a:lstStyle/>
        <a:p>
          <a:endParaRPr lang="en-US"/>
        </a:p>
      </dgm:t>
    </dgm:pt>
    <dgm:pt modelId="{36CA84CD-22B6-CD46-AD4E-28F428432B52}" type="pres">
      <dgm:prSet presAssocID="{12691330-6F94-7343-8F3E-5B2324E2325A}" presName="hierRoot1" presStyleCnt="0"/>
      <dgm:spPr/>
    </dgm:pt>
    <dgm:pt modelId="{9D58C000-FBDC-7D4E-8815-280D4591C6D1}" type="pres">
      <dgm:prSet presAssocID="{12691330-6F94-7343-8F3E-5B2324E2325A}" presName="composite" presStyleCnt="0"/>
      <dgm:spPr/>
    </dgm:pt>
    <dgm:pt modelId="{C5564295-A2F9-7942-BA6B-4539318F13D7}" type="pres">
      <dgm:prSet presAssocID="{12691330-6F94-7343-8F3E-5B2324E2325A}" presName="background" presStyleLbl="node0" presStyleIdx="0" presStyleCnt="1"/>
      <dgm:spPr/>
    </dgm:pt>
    <dgm:pt modelId="{B4B20D3A-DB79-A241-812A-2A7BBD374565}" type="pres">
      <dgm:prSet presAssocID="{12691330-6F94-7343-8F3E-5B2324E2325A}" presName="text" presStyleLbl="fgAcc0" presStyleIdx="0" presStyleCnt="1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90F8035B-03D8-AD46-907A-1A03E737D959}" type="pres">
      <dgm:prSet presAssocID="{12691330-6F94-7343-8F3E-5B2324E2325A}" presName="hierChild2" presStyleCnt="0"/>
      <dgm:spPr/>
    </dgm:pt>
    <dgm:pt modelId="{B75598F6-28B6-C946-8DC9-47B1DB254A8D}" type="pres">
      <dgm:prSet presAssocID="{91D01A44-16D1-4641-89FB-1B2E6C588F67}" presName="Name10" presStyleLbl="parChTrans1D2" presStyleIdx="0" presStyleCnt="2"/>
      <dgm:spPr/>
      <dgm:t>
        <a:bodyPr/>
        <a:lstStyle/>
        <a:p>
          <a:endParaRPr lang="en-US"/>
        </a:p>
      </dgm:t>
    </dgm:pt>
    <dgm:pt modelId="{778B52F1-6472-3744-B8DC-9531C1F19803}" type="pres">
      <dgm:prSet presAssocID="{D90B79BB-3114-BB4E-A83D-A3C6F5D84DEC}" presName="hierRoot2" presStyleCnt="0"/>
      <dgm:spPr/>
    </dgm:pt>
    <dgm:pt modelId="{87E4443C-01E3-7E45-B19E-B3D4C80969D1}" type="pres">
      <dgm:prSet presAssocID="{D90B79BB-3114-BB4E-A83D-A3C6F5D84DEC}" presName="composite2" presStyleCnt="0"/>
      <dgm:spPr/>
    </dgm:pt>
    <dgm:pt modelId="{2B146940-E059-2944-BF65-EA87FD688AC9}" type="pres">
      <dgm:prSet presAssocID="{D90B79BB-3114-BB4E-A83D-A3C6F5D84DEC}" presName="background2" presStyleLbl="node2" presStyleIdx="0" presStyleCnt="2"/>
      <dgm:spPr/>
    </dgm:pt>
    <dgm:pt modelId="{CB3D9721-3020-4243-A708-C0096848BFE7}" type="pres">
      <dgm:prSet presAssocID="{D90B79BB-3114-BB4E-A83D-A3C6F5D84DEC}" presName="text2" presStyleLbl="fgAcc2" presStyleIdx="0" presStyleCnt="2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03E7E43E-119B-5943-A84E-DD295EE2B47B}" type="pres">
      <dgm:prSet presAssocID="{D90B79BB-3114-BB4E-A83D-A3C6F5D84DEC}" presName="hierChild3" presStyleCnt="0"/>
      <dgm:spPr/>
    </dgm:pt>
    <dgm:pt modelId="{43F0D894-3CB7-8E4A-BB5E-126E2F3532AD}" type="pres">
      <dgm:prSet presAssocID="{F6225075-1722-A24F-AC03-F5646CD5FF30}" presName="Name17" presStyleLbl="parChTrans1D3" presStyleIdx="0" presStyleCnt="4"/>
      <dgm:spPr/>
      <dgm:t>
        <a:bodyPr/>
        <a:lstStyle/>
        <a:p>
          <a:endParaRPr lang="en-US"/>
        </a:p>
      </dgm:t>
    </dgm:pt>
    <dgm:pt modelId="{E1753A89-2866-AE42-8F9A-FE7167FF7648}" type="pres">
      <dgm:prSet presAssocID="{EC785628-EFE1-3241-B928-71BA71F4F978}" presName="hierRoot3" presStyleCnt="0"/>
      <dgm:spPr/>
    </dgm:pt>
    <dgm:pt modelId="{D25A5934-E405-4E45-AC4E-FBE2F409A579}" type="pres">
      <dgm:prSet presAssocID="{EC785628-EFE1-3241-B928-71BA71F4F978}" presName="composite3" presStyleCnt="0"/>
      <dgm:spPr/>
    </dgm:pt>
    <dgm:pt modelId="{D63FB592-4930-8645-93AF-78380E5B956F}" type="pres">
      <dgm:prSet presAssocID="{EC785628-EFE1-3241-B928-71BA71F4F978}" presName="background3" presStyleLbl="node3" presStyleIdx="0" presStyleCnt="4"/>
      <dgm:spPr/>
    </dgm:pt>
    <dgm:pt modelId="{9B1B7B8B-0937-D346-B0A2-EE588412136A}" type="pres">
      <dgm:prSet presAssocID="{EC785628-EFE1-3241-B928-71BA71F4F978}" presName="text3" presStyleLbl="fgAcc3" presStyleIdx="0" presStyleCnt="4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1AEA908F-FFAB-994B-9D8A-C304C693D96A}" type="pres">
      <dgm:prSet presAssocID="{EC785628-EFE1-3241-B928-71BA71F4F978}" presName="hierChild4" presStyleCnt="0"/>
      <dgm:spPr/>
    </dgm:pt>
    <dgm:pt modelId="{213951CC-5EE6-A447-AB59-5EDED21D8883}" type="pres">
      <dgm:prSet presAssocID="{41E8D1A8-D995-F746-AFD5-1CF0A529B119}" presName="Name23" presStyleLbl="parChTrans1D4" presStyleIdx="0" presStyleCnt="5"/>
      <dgm:spPr/>
      <dgm:t>
        <a:bodyPr/>
        <a:lstStyle/>
        <a:p>
          <a:endParaRPr lang="en-US"/>
        </a:p>
      </dgm:t>
    </dgm:pt>
    <dgm:pt modelId="{E2BA1E0F-8E24-074F-8D3F-16E5CA0C0C9A}" type="pres">
      <dgm:prSet presAssocID="{95EBF237-1DF4-9947-96BC-268F799DAEBC}" presName="hierRoot4" presStyleCnt="0"/>
      <dgm:spPr/>
    </dgm:pt>
    <dgm:pt modelId="{2F8427EC-100B-A344-AFCA-29245958FC4B}" type="pres">
      <dgm:prSet presAssocID="{95EBF237-1DF4-9947-96BC-268F799DAEBC}" presName="composite4" presStyleCnt="0"/>
      <dgm:spPr/>
    </dgm:pt>
    <dgm:pt modelId="{2FE059E0-EAA8-7140-A252-53728EF3D74F}" type="pres">
      <dgm:prSet presAssocID="{95EBF237-1DF4-9947-96BC-268F799DAEBC}" presName="background4" presStyleLbl="node4" presStyleIdx="0" presStyleCnt="5"/>
      <dgm:spPr/>
    </dgm:pt>
    <dgm:pt modelId="{E28126F7-ED8B-C144-9EE8-42BE1085838E}" type="pres">
      <dgm:prSet presAssocID="{95EBF237-1DF4-9947-96BC-268F799DAEBC}" presName="text4" presStyleLbl="fgAcc4" presStyleIdx="0" presStyleCnt="5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6EF0038F-1529-8147-B246-795722A10277}" type="pres">
      <dgm:prSet presAssocID="{95EBF237-1DF4-9947-96BC-268F799DAEBC}" presName="hierChild5" presStyleCnt="0"/>
      <dgm:spPr/>
    </dgm:pt>
    <dgm:pt modelId="{D260344F-5A95-5648-845B-B731997D3E5E}" type="pres">
      <dgm:prSet presAssocID="{FB923C19-83B1-E243-AF56-C2785316ACE6}" presName="Name23" presStyleLbl="parChTrans1D4" presStyleIdx="1" presStyleCnt="5"/>
      <dgm:spPr/>
      <dgm:t>
        <a:bodyPr/>
        <a:lstStyle/>
        <a:p>
          <a:endParaRPr lang="en-US"/>
        </a:p>
      </dgm:t>
    </dgm:pt>
    <dgm:pt modelId="{EF841757-C87C-A04E-9831-996D63CAA670}" type="pres">
      <dgm:prSet presAssocID="{FFD1CA6F-1C56-F843-A4C7-0590026072B3}" presName="hierRoot4" presStyleCnt="0"/>
      <dgm:spPr/>
    </dgm:pt>
    <dgm:pt modelId="{37DE4C55-618F-684F-9CB8-1E8860CA5155}" type="pres">
      <dgm:prSet presAssocID="{FFD1CA6F-1C56-F843-A4C7-0590026072B3}" presName="composite4" presStyleCnt="0"/>
      <dgm:spPr/>
    </dgm:pt>
    <dgm:pt modelId="{BDCC261F-E1F0-2941-B8BD-7126ED66B10C}" type="pres">
      <dgm:prSet presAssocID="{FFD1CA6F-1C56-F843-A4C7-0590026072B3}" presName="background4" presStyleLbl="node4" presStyleIdx="1" presStyleCnt="5"/>
      <dgm:spPr/>
    </dgm:pt>
    <dgm:pt modelId="{F8E4BBC7-2FB8-5249-8FE4-AAEFA56BAA33}" type="pres">
      <dgm:prSet presAssocID="{FFD1CA6F-1C56-F843-A4C7-0590026072B3}" presName="text4" presStyleLbl="fgAcc4" presStyleIdx="1" presStyleCnt="5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D5577A34-4E0A-2940-953B-3DC98B23D46F}" type="pres">
      <dgm:prSet presAssocID="{FFD1CA6F-1C56-F843-A4C7-0590026072B3}" presName="hierChild5" presStyleCnt="0"/>
      <dgm:spPr/>
    </dgm:pt>
    <dgm:pt modelId="{F6894DF5-5879-8348-A4F8-8962C62FA8A1}" type="pres">
      <dgm:prSet presAssocID="{E4903445-E5D7-3E46-9B10-98C4A3BD2C1D}" presName="Name17" presStyleLbl="parChTrans1D3" presStyleIdx="1" presStyleCnt="4"/>
      <dgm:spPr/>
      <dgm:t>
        <a:bodyPr/>
        <a:lstStyle/>
        <a:p>
          <a:endParaRPr lang="en-US"/>
        </a:p>
      </dgm:t>
    </dgm:pt>
    <dgm:pt modelId="{1E2F4A4F-C582-394D-9E55-478AACEB8D0D}" type="pres">
      <dgm:prSet presAssocID="{55A62BB0-0C85-2548-A2AC-F480529B3235}" presName="hierRoot3" presStyleCnt="0"/>
      <dgm:spPr/>
    </dgm:pt>
    <dgm:pt modelId="{42FC6C98-F283-634F-A227-EEBC52D8590A}" type="pres">
      <dgm:prSet presAssocID="{55A62BB0-0C85-2548-A2AC-F480529B3235}" presName="composite3" presStyleCnt="0"/>
      <dgm:spPr/>
    </dgm:pt>
    <dgm:pt modelId="{7AB9D9A2-2BBA-1C4C-8772-F0BAFAD723AF}" type="pres">
      <dgm:prSet presAssocID="{55A62BB0-0C85-2548-A2AC-F480529B3235}" presName="background3" presStyleLbl="node3" presStyleIdx="1" presStyleCnt="4"/>
      <dgm:spPr/>
    </dgm:pt>
    <dgm:pt modelId="{F1685F0A-F0A9-8B43-9539-C84DC742ED62}" type="pres">
      <dgm:prSet presAssocID="{55A62BB0-0C85-2548-A2AC-F480529B3235}" presName="text3" presStyleLbl="fgAcc3" presStyleIdx="1" presStyleCnt="4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B1EA03FD-8093-6A4B-96BE-241FD5AE7401}" type="pres">
      <dgm:prSet presAssocID="{55A62BB0-0C85-2548-A2AC-F480529B3235}" presName="hierChild4" presStyleCnt="0"/>
      <dgm:spPr/>
    </dgm:pt>
    <dgm:pt modelId="{D7BDF67D-8FA6-AC4C-9D04-66B81F6A13C0}" type="pres">
      <dgm:prSet presAssocID="{90AB2523-EC98-3644-B888-3ECEB6853A1D}" presName="Name17" presStyleLbl="parChTrans1D3" presStyleIdx="2" presStyleCnt="4"/>
      <dgm:spPr/>
      <dgm:t>
        <a:bodyPr/>
        <a:lstStyle/>
        <a:p>
          <a:endParaRPr lang="en-US"/>
        </a:p>
      </dgm:t>
    </dgm:pt>
    <dgm:pt modelId="{C01AA11B-6A68-9644-9E08-D5FC7AF827B6}" type="pres">
      <dgm:prSet presAssocID="{E3CDEEEF-BDCB-AA46-8517-2725DFE0F661}" presName="hierRoot3" presStyleCnt="0"/>
      <dgm:spPr/>
    </dgm:pt>
    <dgm:pt modelId="{C09C9089-550C-8949-8A35-67646A240D73}" type="pres">
      <dgm:prSet presAssocID="{E3CDEEEF-BDCB-AA46-8517-2725DFE0F661}" presName="composite3" presStyleCnt="0"/>
      <dgm:spPr/>
    </dgm:pt>
    <dgm:pt modelId="{90D22B4D-18AA-4A4A-8C86-C9FFBD9FF26A}" type="pres">
      <dgm:prSet presAssocID="{E3CDEEEF-BDCB-AA46-8517-2725DFE0F661}" presName="background3" presStyleLbl="node3" presStyleIdx="2" presStyleCnt="4"/>
      <dgm:spPr/>
    </dgm:pt>
    <dgm:pt modelId="{0A13A63A-DD07-304B-AC89-92A52D8A5BD0}" type="pres">
      <dgm:prSet presAssocID="{E3CDEEEF-BDCB-AA46-8517-2725DFE0F661}" presName="text3" presStyleLbl="fgAcc3" presStyleIdx="2" presStyleCnt="4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4FF8D54C-E47C-7548-AF99-35CE3860B0B8}" type="pres">
      <dgm:prSet presAssocID="{E3CDEEEF-BDCB-AA46-8517-2725DFE0F661}" presName="hierChild4" presStyleCnt="0"/>
      <dgm:spPr/>
    </dgm:pt>
    <dgm:pt modelId="{446F4E67-88BC-7A43-A852-CC883EE6C715}" type="pres">
      <dgm:prSet presAssocID="{4C4F30BB-D2EE-8846-81C0-8B43694EA471}" presName="Name17" presStyleLbl="parChTrans1D3" presStyleIdx="3" presStyleCnt="4"/>
      <dgm:spPr/>
      <dgm:t>
        <a:bodyPr/>
        <a:lstStyle/>
        <a:p>
          <a:endParaRPr lang="en-US"/>
        </a:p>
      </dgm:t>
    </dgm:pt>
    <dgm:pt modelId="{B8853746-F6D4-A540-A975-6A1326568EAA}" type="pres">
      <dgm:prSet presAssocID="{39B590C7-FE92-8844-9C15-BDADD53DB43C}" presName="hierRoot3" presStyleCnt="0"/>
      <dgm:spPr/>
    </dgm:pt>
    <dgm:pt modelId="{15BC839D-D2F8-E24D-9741-4E6B19970502}" type="pres">
      <dgm:prSet presAssocID="{39B590C7-FE92-8844-9C15-BDADD53DB43C}" presName="composite3" presStyleCnt="0"/>
      <dgm:spPr/>
    </dgm:pt>
    <dgm:pt modelId="{53F44CD7-C445-234E-9598-74EA875913BD}" type="pres">
      <dgm:prSet presAssocID="{39B590C7-FE92-8844-9C15-BDADD53DB43C}" presName="background3" presStyleLbl="node3" presStyleIdx="3" presStyleCnt="4"/>
      <dgm:spPr/>
    </dgm:pt>
    <dgm:pt modelId="{96AF6CF4-C09F-E040-87E9-710D41D36CF8}" type="pres">
      <dgm:prSet presAssocID="{39B590C7-FE92-8844-9C15-BDADD53DB43C}" presName="text3" presStyleLbl="fgAcc3" presStyleIdx="3" presStyleCnt="4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3433FC5F-FE51-5040-8A04-3F9AFE7D77E3}" type="pres">
      <dgm:prSet presAssocID="{39B590C7-FE92-8844-9C15-BDADD53DB43C}" presName="hierChild4" presStyleCnt="0"/>
      <dgm:spPr/>
    </dgm:pt>
    <dgm:pt modelId="{A33D5B56-0EA0-D945-B658-4D3F3A77EEDD}" type="pres">
      <dgm:prSet presAssocID="{C41C5276-EF16-B048-8C35-AAC745270F58}" presName="Name23" presStyleLbl="parChTrans1D4" presStyleIdx="2" presStyleCnt="5"/>
      <dgm:spPr/>
      <dgm:t>
        <a:bodyPr/>
        <a:lstStyle/>
        <a:p>
          <a:endParaRPr lang="en-US"/>
        </a:p>
      </dgm:t>
    </dgm:pt>
    <dgm:pt modelId="{F47B2FC4-6282-2C42-9DDD-04D1E52FD223}" type="pres">
      <dgm:prSet presAssocID="{F7CD9937-968C-2C46-B6EA-ED36AA06E128}" presName="hierRoot4" presStyleCnt="0"/>
      <dgm:spPr/>
    </dgm:pt>
    <dgm:pt modelId="{57BEAB95-2E6F-8C49-8373-7EDC976931F9}" type="pres">
      <dgm:prSet presAssocID="{F7CD9937-968C-2C46-B6EA-ED36AA06E128}" presName="composite4" presStyleCnt="0"/>
      <dgm:spPr/>
    </dgm:pt>
    <dgm:pt modelId="{5477B4F8-B591-D147-B879-3D0CC6329F19}" type="pres">
      <dgm:prSet presAssocID="{F7CD9937-968C-2C46-B6EA-ED36AA06E128}" presName="background4" presStyleLbl="node4" presStyleIdx="2" presStyleCnt="5"/>
      <dgm:spPr/>
    </dgm:pt>
    <dgm:pt modelId="{2DC3A4D2-4B36-AA48-A363-EF5FAB102D0B}" type="pres">
      <dgm:prSet presAssocID="{F7CD9937-968C-2C46-B6EA-ED36AA06E128}" presName="text4" presStyleLbl="fgAcc4" presStyleIdx="2" presStyleCnt="5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D8402163-8307-C34F-988A-69311C8FCC53}" type="pres">
      <dgm:prSet presAssocID="{F7CD9937-968C-2C46-B6EA-ED36AA06E128}" presName="hierChild5" presStyleCnt="0"/>
      <dgm:spPr/>
    </dgm:pt>
    <dgm:pt modelId="{D7586BF2-31A1-0147-AA53-A1D6B571A49E}" type="pres">
      <dgm:prSet presAssocID="{BA5AD8F3-B568-9344-8CEE-0276BE38E893}" presName="Name23" presStyleLbl="parChTrans1D4" presStyleIdx="3" presStyleCnt="5"/>
      <dgm:spPr/>
      <dgm:t>
        <a:bodyPr/>
        <a:lstStyle/>
        <a:p>
          <a:endParaRPr lang="en-US"/>
        </a:p>
      </dgm:t>
    </dgm:pt>
    <dgm:pt modelId="{CDC46534-D13E-4242-B60C-2CC33E6682B4}" type="pres">
      <dgm:prSet presAssocID="{3C5CCC3F-4310-854A-BDC4-202A114F19F2}" presName="hierRoot4" presStyleCnt="0"/>
      <dgm:spPr/>
    </dgm:pt>
    <dgm:pt modelId="{656FC198-09F4-8B43-98FB-BB98F42F907F}" type="pres">
      <dgm:prSet presAssocID="{3C5CCC3F-4310-854A-BDC4-202A114F19F2}" presName="composite4" presStyleCnt="0"/>
      <dgm:spPr/>
    </dgm:pt>
    <dgm:pt modelId="{3349BB63-9067-664C-BA08-3C773FA89C23}" type="pres">
      <dgm:prSet presAssocID="{3C5CCC3F-4310-854A-BDC4-202A114F19F2}" presName="background4" presStyleLbl="node4" presStyleIdx="3" presStyleCnt="5"/>
      <dgm:spPr/>
    </dgm:pt>
    <dgm:pt modelId="{729A0B73-F774-B24C-9D96-22BE41F788A2}" type="pres">
      <dgm:prSet presAssocID="{3C5CCC3F-4310-854A-BDC4-202A114F19F2}" presName="text4" presStyleLbl="fgAcc4" presStyleIdx="3" presStyleCnt="5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8FDF5380-2820-7F40-8C56-99933729CBAE}" type="pres">
      <dgm:prSet presAssocID="{3C5CCC3F-4310-854A-BDC4-202A114F19F2}" presName="hierChild5" presStyleCnt="0"/>
      <dgm:spPr/>
    </dgm:pt>
    <dgm:pt modelId="{D9113A05-D511-1F40-929D-719CA4232259}" type="pres">
      <dgm:prSet presAssocID="{7AC76103-7B93-A945-8E73-E7A35AF95F29}" presName="Name23" presStyleLbl="parChTrans1D4" presStyleIdx="4" presStyleCnt="5"/>
      <dgm:spPr/>
      <dgm:t>
        <a:bodyPr/>
        <a:lstStyle/>
        <a:p>
          <a:endParaRPr lang="en-US"/>
        </a:p>
      </dgm:t>
    </dgm:pt>
    <dgm:pt modelId="{7706DEC9-72A2-2E4D-A873-294A51CE315A}" type="pres">
      <dgm:prSet presAssocID="{ABDA5E5B-712A-0A40-843E-90A4F93CC7DF}" presName="hierRoot4" presStyleCnt="0"/>
      <dgm:spPr/>
    </dgm:pt>
    <dgm:pt modelId="{CD6ADB72-69B0-6842-863C-CB02822ACEE6}" type="pres">
      <dgm:prSet presAssocID="{ABDA5E5B-712A-0A40-843E-90A4F93CC7DF}" presName="composite4" presStyleCnt="0"/>
      <dgm:spPr/>
    </dgm:pt>
    <dgm:pt modelId="{2DC54CE6-DEBF-724A-9187-9C34D64926B2}" type="pres">
      <dgm:prSet presAssocID="{ABDA5E5B-712A-0A40-843E-90A4F93CC7DF}" presName="background4" presStyleLbl="node4" presStyleIdx="4" presStyleCnt="5"/>
      <dgm:spPr/>
    </dgm:pt>
    <dgm:pt modelId="{67614E9A-406B-FD4F-9E39-9520F5A91A83}" type="pres">
      <dgm:prSet presAssocID="{ABDA5E5B-712A-0A40-843E-90A4F93CC7DF}" presName="text4" presStyleLbl="fgAcc4" presStyleIdx="4" presStyleCnt="5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040B232D-61DF-4042-AEAE-D462D1A96720}" type="pres">
      <dgm:prSet presAssocID="{ABDA5E5B-712A-0A40-843E-90A4F93CC7DF}" presName="hierChild5" presStyleCnt="0"/>
      <dgm:spPr/>
    </dgm:pt>
    <dgm:pt modelId="{32679EFE-854F-F941-8FE3-C13B60CB7216}" type="pres">
      <dgm:prSet presAssocID="{F162D4F8-1D1F-634D-A78A-C8110FDCA41A}" presName="Name10" presStyleLbl="parChTrans1D2" presStyleIdx="1" presStyleCnt="2"/>
      <dgm:spPr/>
      <dgm:t>
        <a:bodyPr/>
        <a:lstStyle/>
        <a:p>
          <a:endParaRPr lang="en-US"/>
        </a:p>
      </dgm:t>
    </dgm:pt>
    <dgm:pt modelId="{3AAC2DF9-B421-FC46-81F3-FAEF9E132194}" type="pres">
      <dgm:prSet presAssocID="{F95A066A-376B-0F44-829F-B3BB2C01B4EA}" presName="hierRoot2" presStyleCnt="0"/>
      <dgm:spPr/>
    </dgm:pt>
    <dgm:pt modelId="{9C49EE25-388F-984C-9FFD-A6CBD2567834}" type="pres">
      <dgm:prSet presAssocID="{F95A066A-376B-0F44-829F-B3BB2C01B4EA}" presName="composite2" presStyleCnt="0"/>
      <dgm:spPr/>
    </dgm:pt>
    <dgm:pt modelId="{8E02BD0C-9C2C-C640-9256-674102800903}" type="pres">
      <dgm:prSet presAssocID="{F95A066A-376B-0F44-829F-B3BB2C01B4EA}" presName="background2" presStyleLbl="node2" presStyleIdx="1" presStyleCnt="2"/>
      <dgm:spPr/>
    </dgm:pt>
    <dgm:pt modelId="{0736A4EC-7AD2-754B-9EB3-AA700478FD72}" type="pres">
      <dgm:prSet presAssocID="{F95A066A-376B-0F44-829F-B3BB2C01B4EA}" presName="text2" presStyleLbl="fgAcc2" presStyleIdx="1" presStyleCnt="2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FA5901C7-AFEC-B548-A33B-BC1F17D68908}" type="pres">
      <dgm:prSet presAssocID="{F95A066A-376B-0F44-829F-B3BB2C01B4EA}" presName="hierChild3" presStyleCnt="0"/>
      <dgm:spPr/>
    </dgm:pt>
  </dgm:ptLst>
  <dgm:cxnLst>
    <dgm:cxn modelId="{0EB25DBC-7F08-B749-9282-F7128BB80B8D}" type="presOf" srcId="{90AB2523-EC98-3644-B888-3ECEB6853A1D}" destId="{D7BDF67D-8FA6-AC4C-9D04-66B81F6A13C0}" srcOrd="0" destOrd="0" presId="urn:microsoft.com/office/officeart/2005/8/layout/hierarchy1"/>
    <dgm:cxn modelId="{3147213C-BB4E-8849-8A29-2DE4506FE663}" srcId="{D90B79BB-3114-BB4E-A83D-A3C6F5D84DEC}" destId="{39B590C7-FE92-8844-9C15-BDADD53DB43C}" srcOrd="3" destOrd="0" parTransId="{4C4F30BB-D2EE-8846-81C0-8B43694EA471}" sibTransId="{E580A5A5-9F94-3D4C-80E6-0153AB9A8787}"/>
    <dgm:cxn modelId="{A9F68B56-70C2-8148-8BBA-C799CAAE8659}" type="presOf" srcId="{4C4F30BB-D2EE-8846-81C0-8B43694EA471}" destId="{446F4E67-88BC-7A43-A852-CC883EE6C715}" srcOrd="0" destOrd="0" presId="urn:microsoft.com/office/officeart/2005/8/layout/hierarchy1"/>
    <dgm:cxn modelId="{87E5A8AD-141A-4A4E-969C-8415E22BEF08}" type="presOf" srcId="{F162D4F8-1D1F-634D-A78A-C8110FDCA41A}" destId="{32679EFE-854F-F941-8FE3-C13B60CB7216}" srcOrd="0" destOrd="0" presId="urn:microsoft.com/office/officeart/2005/8/layout/hierarchy1"/>
    <dgm:cxn modelId="{E972F09A-664D-E645-A786-BC34F2A58A23}" srcId="{EC785628-EFE1-3241-B928-71BA71F4F978}" destId="{FFD1CA6F-1C56-F843-A4C7-0590026072B3}" srcOrd="1" destOrd="0" parTransId="{FB923C19-83B1-E243-AF56-C2785316ACE6}" sibTransId="{A053F64B-5220-3B42-AADD-7C2849B37549}"/>
    <dgm:cxn modelId="{7BA102EF-0741-054A-89B3-B9B953ADD6F2}" type="presOf" srcId="{41E8D1A8-D995-F746-AFD5-1CF0A529B119}" destId="{213951CC-5EE6-A447-AB59-5EDED21D8883}" srcOrd="0" destOrd="0" presId="urn:microsoft.com/office/officeart/2005/8/layout/hierarchy1"/>
    <dgm:cxn modelId="{8A6A507C-971A-1C48-A15A-DC795B461533}" type="presOf" srcId="{E3CDEEEF-BDCB-AA46-8517-2725DFE0F661}" destId="{0A13A63A-DD07-304B-AC89-92A52D8A5BD0}" srcOrd="0" destOrd="0" presId="urn:microsoft.com/office/officeart/2005/8/layout/hierarchy1"/>
    <dgm:cxn modelId="{7FC255D7-1805-1A40-9FCF-E1CBF9A05AE5}" srcId="{E18B77DE-4383-C94D-9D2B-227A1F65E237}" destId="{12691330-6F94-7343-8F3E-5B2324E2325A}" srcOrd="0" destOrd="0" parTransId="{6AFAF9EE-83A7-FB45-A5C9-F7778FEB4DBB}" sibTransId="{3A6AB3D5-52F1-664C-9A72-844ADF974F81}"/>
    <dgm:cxn modelId="{652DE6B0-1CA0-E64A-8B0F-A78CB06B783F}" type="presOf" srcId="{55A62BB0-0C85-2548-A2AC-F480529B3235}" destId="{F1685F0A-F0A9-8B43-9539-C84DC742ED62}" srcOrd="0" destOrd="0" presId="urn:microsoft.com/office/officeart/2005/8/layout/hierarchy1"/>
    <dgm:cxn modelId="{DBC2C0E1-AA19-894F-8D0A-062D676476FA}" srcId="{D90B79BB-3114-BB4E-A83D-A3C6F5D84DEC}" destId="{E3CDEEEF-BDCB-AA46-8517-2725DFE0F661}" srcOrd="2" destOrd="0" parTransId="{90AB2523-EC98-3644-B888-3ECEB6853A1D}" sibTransId="{A5428490-24A4-3149-8430-CD1166B86A8F}"/>
    <dgm:cxn modelId="{F03D4638-4DB0-544C-BDC9-15EE5E9EA356}" type="presOf" srcId="{12691330-6F94-7343-8F3E-5B2324E2325A}" destId="{B4B20D3A-DB79-A241-812A-2A7BBD374565}" srcOrd="0" destOrd="0" presId="urn:microsoft.com/office/officeart/2005/8/layout/hierarchy1"/>
    <dgm:cxn modelId="{F213C83A-71A8-7946-B84C-B6F1FD2635F7}" type="presOf" srcId="{F6225075-1722-A24F-AC03-F5646CD5FF30}" destId="{43F0D894-3CB7-8E4A-BB5E-126E2F3532AD}" srcOrd="0" destOrd="0" presId="urn:microsoft.com/office/officeart/2005/8/layout/hierarchy1"/>
    <dgm:cxn modelId="{DC30FC4B-0349-7045-88A9-54DCB2B8CD1D}" type="presOf" srcId="{E18B77DE-4383-C94D-9D2B-227A1F65E237}" destId="{FE4C3C45-28F3-4E45-8295-0A78D0718B28}" srcOrd="0" destOrd="0" presId="urn:microsoft.com/office/officeart/2005/8/layout/hierarchy1"/>
    <dgm:cxn modelId="{0D9DAA66-6C5E-2E47-80A0-79A3D9E93EC5}" srcId="{D90B79BB-3114-BB4E-A83D-A3C6F5D84DEC}" destId="{55A62BB0-0C85-2548-A2AC-F480529B3235}" srcOrd="1" destOrd="0" parTransId="{E4903445-E5D7-3E46-9B10-98C4A3BD2C1D}" sibTransId="{D6E4BD27-9EAD-2A4C-AC65-44334DB70060}"/>
    <dgm:cxn modelId="{B1A49922-8E42-BD41-A16B-CB3956B09F17}" type="presOf" srcId="{91D01A44-16D1-4641-89FB-1B2E6C588F67}" destId="{B75598F6-28B6-C946-8DC9-47B1DB254A8D}" srcOrd="0" destOrd="0" presId="urn:microsoft.com/office/officeart/2005/8/layout/hierarchy1"/>
    <dgm:cxn modelId="{65D5D749-E531-7642-81B0-01EAD748FE52}" srcId="{39B590C7-FE92-8844-9C15-BDADD53DB43C}" destId="{3C5CCC3F-4310-854A-BDC4-202A114F19F2}" srcOrd="1" destOrd="0" parTransId="{BA5AD8F3-B568-9344-8CEE-0276BE38E893}" sibTransId="{F0AD0692-53BF-5240-AD82-3D14BAD0A43B}"/>
    <dgm:cxn modelId="{9E0651E2-CCA3-CC4E-B88D-B2896E4D0648}" type="presOf" srcId="{3C5CCC3F-4310-854A-BDC4-202A114F19F2}" destId="{729A0B73-F774-B24C-9D96-22BE41F788A2}" srcOrd="0" destOrd="0" presId="urn:microsoft.com/office/officeart/2005/8/layout/hierarchy1"/>
    <dgm:cxn modelId="{DAA62C3C-CBB8-1D4B-A048-44B14B638D84}" type="presOf" srcId="{D90B79BB-3114-BB4E-A83D-A3C6F5D84DEC}" destId="{CB3D9721-3020-4243-A708-C0096848BFE7}" srcOrd="0" destOrd="0" presId="urn:microsoft.com/office/officeart/2005/8/layout/hierarchy1"/>
    <dgm:cxn modelId="{795467C1-2DED-E146-AE71-68DC0EBE86E5}" type="presOf" srcId="{39B590C7-FE92-8844-9C15-BDADD53DB43C}" destId="{96AF6CF4-C09F-E040-87E9-710D41D36CF8}" srcOrd="0" destOrd="0" presId="urn:microsoft.com/office/officeart/2005/8/layout/hierarchy1"/>
    <dgm:cxn modelId="{F7A67344-6889-5F47-9786-91EA865F4AB9}" srcId="{39B590C7-FE92-8844-9C15-BDADD53DB43C}" destId="{ABDA5E5B-712A-0A40-843E-90A4F93CC7DF}" srcOrd="2" destOrd="0" parTransId="{7AC76103-7B93-A945-8E73-E7A35AF95F29}" sibTransId="{191357D8-2D25-884C-8CCF-5A276820AA05}"/>
    <dgm:cxn modelId="{426E721D-3F6D-0542-B86E-4FEC053B116D}" srcId="{EC785628-EFE1-3241-B928-71BA71F4F978}" destId="{95EBF237-1DF4-9947-96BC-268F799DAEBC}" srcOrd="0" destOrd="0" parTransId="{41E8D1A8-D995-F746-AFD5-1CF0A529B119}" sibTransId="{FBACA171-90C6-434E-9596-3E5E4CEB7861}"/>
    <dgm:cxn modelId="{5AA07E39-4F7A-7F4C-885C-109AD7374244}" type="presOf" srcId="{95EBF237-1DF4-9947-96BC-268F799DAEBC}" destId="{E28126F7-ED8B-C144-9EE8-42BE1085838E}" srcOrd="0" destOrd="0" presId="urn:microsoft.com/office/officeart/2005/8/layout/hierarchy1"/>
    <dgm:cxn modelId="{7B44D46F-27D3-734B-9911-CD10B7BC2CAD}" type="presOf" srcId="{C41C5276-EF16-B048-8C35-AAC745270F58}" destId="{A33D5B56-0EA0-D945-B658-4D3F3A77EEDD}" srcOrd="0" destOrd="0" presId="urn:microsoft.com/office/officeart/2005/8/layout/hierarchy1"/>
    <dgm:cxn modelId="{49971DD5-600A-1D46-BB97-75E13D600155}" type="presOf" srcId="{F7CD9937-968C-2C46-B6EA-ED36AA06E128}" destId="{2DC3A4D2-4B36-AA48-A363-EF5FAB102D0B}" srcOrd="0" destOrd="0" presId="urn:microsoft.com/office/officeart/2005/8/layout/hierarchy1"/>
    <dgm:cxn modelId="{8602DBA7-32B4-9542-B192-B57C7C16301F}" type="presOf" srcId="{E4903445-E5D7-3E46-9B10-98C4A3BD2C1D}" destId="{F6894DF5-5879-8348-A4F8-8962C62FA8A1}" srcOrd="0" destOrd="0" presId="urn:microsoft.com/office/officeart/2005/8/layout/hierarchy1"/>
    <dgm:cxn modelId="{25B01398-F564-3942-B56C-5FB742B6B1BA}" type="presOf" srcId="{FB923C19-83B1-E243-AF56-C2785316ACE6}" destId="{D260344F-5A95-5648-845B-B731997D3E5E}" srcOrd="0" destOrd="0" presId="urn:microsoft.com/office/officeart/2005/8/layout/hierarchy1"/>
    <dgm:cxn modelId="{A09910D1-4829-C145-801E-A2F18A600129}" srcId="{12691330-6F94-7343-8F3E-5B2324E2325A}" destId="{D90B79BB-3114-BB4E-A83D-A3C6F5D84DEC}" srcOrd="0" destOrd="0" parTransId="{91D01A44-16D1-4641-89FB-1B2E6C588F67}" sibTransId="{0500F052-EDC0-E543-AC5F-A67F26188B5B}"/>
    <dgm:cxn modelId="{AF1AB2AE-4800-D244-BF19-488EDEE971C3}" type="presOf" srcId="{BA5AD8F3-B568-9344-8CEE-0276BE38E893}" destId="{D7586BF2-31A1-0147-AA53-A1D6B571A49E}" srcOrd="0" destOrd="0" presId="urn:microsoft.com/office/officeart/2005/8/layout/hierarchy1"/>
    <dgm:cxn modelId="{3782A76E-9649-354E-A285-A58B99F3FB59}" srcId="{D90B79BB-3114-BB4E-A83D-A3C6F5D84DEC}" destId="{EC785628-EFE1-3241-B928-71BA71F4F978}" srcOrd="0" destOrd="0" parTransId="{F6225075-1722-A24F-AC03-F5646CD5FF30}" sibTransId="{567493BF-6920-5A4C-BFC2-3B55EF0D722C}"/>
    <dgm:cxn modelId="{58CF4048-2138-BF47-8F9B-10B49D0C185C}" type="presOf" srcId="{ABDA5E5B-712A-0A40-843E-90A4F93CC7DF}" destId="{67614E9A-406B-FD4F-9E39-9520F5A91A83}" srcOrd="0" destOrd="0" presId="urn:microsoft.com/office/officeart/2005/8/layout/hierarchy1"/>
    <dgm:cxn modelId="{41DC15F3-3257-C84F-9C10-A46A3431F564}" srcId="{12691330-6F94-7343-8F3E-5B2324E2325A}" destId="{F95A066A-376B-0F44-829F-B3BB2C01B4EA}" srcOrd="1" destOrd="0" parTransId="{F162D4F8-1D1F-634D-A78A-C8110FDCA41A}" sibTransId="{38AADBF0-3EFA-1541-8FFF-A07C0261A270}"/>
    <dgm:cxn modelId="{6F6F7788-BD30-DC45-8168-F3DC2604FC31}" type="presOf" srcId="{FFD1CA6F-1C56-F843-A4C7-0590026072B3}" destId="{F8E4BBC7-2FB8-5249-8FE4-AAEFA56BAA33}" srcOrd="0" destOrd="0" presId="urn:microsoft.com/office/officeart/2005/8/layout/hierarchy1"/>
    <dgm:cxn modelId="{BCE0E3A7-72F8-AD47-8D52-962687408401}" srcId="{39B590C7-FE92-8844-9C15-BDADD53DB43C}" destId="{F7CD9937-968C-2C46-B6EA-ED36AA06E128}" srcOrd="0" destOrd="0" parTransId="{C41C5276-EF16-B048-8C35-AAC745270F58}" sibTransId="{691E1742-F259-5747-8CC3-3C131C33389E}"/>
    <dgm:cxn modelId="{476A036A-D5D3-A04D-87A8-B4F5DBEFF35B}" type="presOf" srcId="{7AC76103-7B93-A945-8E73-E7A35AF95F29}" destId="{D9113A05-D511-1F40-929D-719CA4232259}" srcOrd="0" destOrd="0" presId="urn:microsoft.com/office/officeart/2005/8/layout/hierarchy1"/>
    <dgm:cxn modelId="{D1F83B67-A0A2-364F-A27D-61CFFFA4F5E5}" type="presOf" srcId="{F95A066A-376B-0F44-829F-B3BB2C01B4EA}" destId="{0736A4EC-7AD2-754B-9EB3-AA700478FD72}" srcOrd="0" destOrd="0" presId="urn:microsoft.com/office/officeart/2005/8/layout/hierarchy1"/>
    <dgm:cxn modelId="{B1F99A9D-5F5E-6848-AF61-6E1151E56475}" type="presOf" srcId="{EC785628-EFE1-3241-B928-71BA71F4F978}" destId="{9B1B7B8B-0937-D346-B0A2-EE588412136A}" srcOrd="0" destOrd="0" presId="urn:microsoft.com/office/officeart/2005/8/layout/hierarchy1"/>
    <dgm:cxn modelId="{93647B15-D3DD-534F-B5C8-198285541A81}" type="presParOf" srcId="{FE4C3C45-28F3-4E45-8295-0A78D0718B28}" destId="{36CA84CD-22B6-CD46-AD4E-28F428432B52}" srcOrd="0" destOrd="0" presId="urn:microsoft.com/office/officeart/2005/8/layout/hierarchy1"/>
    <dgm:cxn modelId="{EDD523CF-54AA-E041-98AA-343EED349CD0}" type="presParOf" srcId="{36CA84CD-22B6-CD46-AD4E-28F428432B52}" destId="{9D58C000-FBDC-7D4E-8815-280D4591C6D1}" srcOrd="0" destOrd="0" presId="urn:microsoft.com/office/officeart/2005/8/layout/hierarchy1"/>
    <dgm:cxn modelId="{4C8FA00B-36C0-6146-B7DD-C5F3C589C971}" type="presParOf" srcId="{9D58C000-FBDC-7D4E-8815-280D4591C6D1}" destId="{C5564295-A2F9-7942-BA6B-4539318F13D7}" srcOrd="0" destOrd="0" presId="urn:microsoft.com/office/officeart/2005/8/layout/hierarchy1"/>
    <dgm:cxn modelId="{A68927C1-5798-6A44-A957-E5B82A091C4C}" type="presParOf" srcId="{9D58C000-FBDC-7D4E-8815-280D4591C6D1}" destId="{B4B20D3A-DB79-A241-812A-2A7BBD374565}" srcOrd="1" destOrd="0" presId="urn:microsoft.com/office/officeart/2005/8/layout/hierarchy1"/>
    <dgm:cxn modelId="{1C84EBEC-C153-E54E-9CBA-7AE5B7DB0A05}" type="presParOf" srcId="{36CA84CD-22B6-CD46-AD4E-28F428432B52}" destId="{90F8035B-03D8-AD46-907A-1A03E737D959}" srcOrd="1" destOrd="0" presId="urn:microsoft.com/office/officeart/2005/8/layout/hierarchy1"/>
    <dgm:cxn modelId="{C2170687-0ACE-AF49-8235-7C36DA0128EB}" type="presParOf" srcId="{90F8035B-03D8-AD46-907A-1A03E737D959}" destId="{B75598F6-28B6-C946-8DC9-47B1DB254A8D}" srcOrd="0" destOrd="0" presId="urn:microsoft.com/office/officeart/2005/8/layout/hierarchy1"/>
    <dgm:cxn modelId="{9BC61FB0-B06B-4047-B287-F1A63D96C14B}" type="presParOf" srcId="{90F8035B-03D8-AD46-907A-1A03E737D959}" destId="{778B52F1-6472-3744-B8DC-9531C1F19803}" srcOrd="1" destOrd="0" presId="urn:microsoft.com/office/officeart/2005/8/layout/hierarchy1"/>
    <dgm:cxn modelId="{1214DB24-F0A7-A542-9D91-C808FCF41ADF}" type="presParOf" srcId="{778B52F1-6472-3744-B8DC-9531C1F19803}" destId="{87E4443C-01E3-7E45-B19E-B3D4C80969D1}" srcOrd="0" destOrd="0" presId="urn:microsoft.com/office/officeart/2005/8/layout/hierarchy1"/>
    <dgm:cxn modelId="{BFECCD1F-2FAD-234E-AC10-E37D2C42593F}" type="presParOf" srcId="{87E4443C-01E3-7E45-B19E-B3D4C80969D1}" destId="{2B146940-E059-2944-BF65-EA87FD688AC9}" srcOrd="0" destOrd="0" presId="urn:microsoft.com/office/officeart/2005/8/layout/hierarchy1"/>
    <dgm:cxn modelId="{1CC07562-5856-AD4C-896D-98AB19C46270}" type="presParOf" srcId="{87E4443C-01E3-7E45-B19E-B3D4C80969D1}" destId="{CB3D9721-3020-4243-A708-C0096848BFE7}" srcOrd="1" destOrd="0" presId="urn:microsoft.com/office/officeart/2005/8/layout/hierarchy1"/>
    <dgm:cxn modelId="{A1FF7C14-685A-554D-AF1A-AA273EA545DC}" type="presParOf" srcId="{778B52F1-6472-3744-B8DC-9531C1F19803}" destId="{03E7E43E-119B-5943-A84E-DD295EE2B47B}" srcOrd="1" destOrd="0" presId="urn:microsoft.com/office/officeart/2005/8/layout/hierarchy1"/>
    <dgm:cxn modelId="{40415298-F18A-354E-8787-5717A4B36398}" type="presParOf" srcId="{03E7E43E-119B-5943-A84E-DD295EE2B47B}" destId="{43F0D894-3CB7-8E4A-BB5E-126E2F3532AD}" srcOrd="0" destOrd="0" presId="urn:microsoft.com/office/officeart/2005/8/layout/hierarchy1"/>
    <dgm:cxn modelId="{EF03C791-2799-D24A-8C5E-73BC0C4CC461}" type="presParOf" srcId="{03E7E43E-119B-5943-A84E-DD295EE2B47B}" destId="{E1753A89-2866-AE42-8F9A-FE7167FF7648}" srcOrd="1" destOrd="0" presId="urn:microsoft.com/office/officeart/2005/8/layout/hierarchy1"/>
    <dgm:cxn modelId="{E862D9B2-81BF-814F-B927-5973F7D7079E}" type="presParOf" srcId="{E1753A89-2866-AE42-8F9A-FE7167FF7648}" destId="{D25A5934-E405-4E45-AC4E-FBE2F409A579}" srcOrd="0" destOrd="0" presId="urn:microsoft.com/office/officeart/2005/8/layout/hierarchy1"/>
    <dgm:cxn modelId="{CC76FBD2-87B8-0945-ABBE-9C4442E8B037}" type="presParOf" srcId="{D25A5934-E405-4E45-AC4E-FBE2F409A579}" destId="{D63FB592-4930-8645-93AF-78380E5B956F}" srcOrd="0" destOrd="0" presId="urn:microsoft.com/office/officeart/2005/8/layout/hierarchy1"/>
    <dgm:cxn modelId="{54C1FEF9-5E07-3348-BF11-07B7F8D1E800}" type="presParOf" srcId="{D25A5934-E405-4E45-AC4E-FBE2F409A579}" destId="{9B1B7B8B-0937-D346-B0A2-EE588412136A}" srcOrd="1" destOrd="0" presId="urn:microsoft.com/office/officeart/2005/8/layout/hierarchy1"/>
    <dgm:cxn modelId="{B165949D-ADD5-3B4B-AE72-EB11EA47E8EF}" type="presParOf" srcId="{E1753A89-2866-AE42-8F9A-FE7167FF7648}" destId="{1AEA908F-FFAB-994B-9D8A-C304C693D96A}" srcOrd="1" destOrd="0" presId="urn:microsoft.com/office/officeart/2005/8/layout/hierarchy1"/>
    <dgm:cxn modelId="{0DA08299-0843-A648-AEE4-166098B4E815}" type="presParOf" srcId="{1AEA908F-FFAB-994B-9D8A-C304C693D96A}" destId="{213951CC-5EE6-A447-AB59-5EDED21D8883}" srcOrd="0" destOrd="0" presId="urn:microsoft.com/office/officeart/2005/8/layout/hierarchy1"/>
    <dgm:cxn modelId="{EE1E110A-C607-4145-9AB6-06ACC65E6275}" type="presParOf" srcId="{1AEA908F-FFAB-994B-9D8A-C304C693D96A}" destId="{E2BA1E0F-8E24-074F-8D3F-16E5CA0C0C9A}" srcOrd="1" destOrd="0" presId="urn:microsoft.com/office/officeart/2005/8/layout/hierarchy1"/>
    <dgm:cxn modelId="{EBF9ED97-CE7B-2B4F-93C2-D29AC50962D9}" type="presParOf" srcId="{E2BA1E0F-8E24-074F-8D3F-16E5CA0C0C9A}" destId="{2F8427EC-100B-A344-AFCA-29245958FC4B}" srcOrd="0" destOrd="0" presId="urn:microsoft.com/office/officeart/2005/8/layout/hierarchy1"/>
    <dgm:cxn modelId="{AF5A510D-8A7A-A847-9777-5F7B14099148}" type="presParOf" srcId="{2F8427EC-100B-A344-AFCA-29245958FC4B}" destId="{2FE059E0-EAA8-7140-A252-53728EF3D74F}" srcOrd="0" destOrd="0" presId="urn:microsoft.com/office/officeart/2005/8/layout/hierarchy1"/>
    <dgm:cxn modelId="{6BFA819F-0130-4844-8AAE-54222A08810E}" type="presParOf" srcId="{2F8427EC-100B-A344-AFCA-29245958FC4B}" destId="{E28126F7-ED8B-C144-9EE8-42BE1085838E}" srcOrd="1" destOrd="0" presId="urn:microsoft.com/office/officeart/2005/8/layout/hierarchy1"/>
    <dgm:cxn modelId="{3BE40C3D-59D8-624D-B635-8E3611605879}" type="presParOf" srcId="{E2BA1E0F-8E24-074F-8D3F-16E5CA0C0C9A}" destId="{6EF0038F-1529-8147-B246-795722A10277}" srcOrd="1" destOrd="0" presId="urn:microsoft.com/office/officeart/2005/8/layout/hierarchy1"/>
    <dgm:cxn modelId="{A6CF33E6-6677-AC47-8816-5447929B53F3}" type="presParOf" srcId="{1AEA908F-FFAB-994B-9D8A-C304C693D96A}" destId="{D260344F-5A95-5648-845B-B731997D3E5E}" srcOrd="2" destOrd="0" presId="urn:microsoft.com/office/officeart/2005/8/layout/hierarchy1"/>
    <dgm:cxn modelId="{9C224E07-647E-2445-96C8-534E0464A204}" type="presParOf" srcId="{1AEA908F-FFAB-994B-9D8A-C304C693D96A}" destId="{EF841757-C87C-A04E-9831-996D63CAA670}" srcOrd="3" destOrd="0" presId="urn:microsoft.com/office/officeart/2005/8/layout/hierarchy1"/>
    <dgm:cxn modelId="{163D0C9F-E332-E842-A72A-33FE3FD20121}" type="presParOf" srcId="{EF841757-C87C-A04E-9831-996D63CAA670}" destId="{37DE4C55-618F-684F-9CB8-1E8860CA5155}" srcOrd="0" destOrd="0" presId="urn:microsoft.com/office/officeart/2005/8/layout/hierarchy1"/>
    <dgm:cxn modelId="{EF410749-B9DA-DB46-8FE7-C0350D8587E3}" type="presParOf" srcId="{37DE4C55-618F-684F-9CB8-1E8860CA5155}" destId="{BDCC261F-E1F0-2941-B8BD-7126ED66B10C}" srcOrd="0" destOrd="0" presId="urn:microsoft.com/office/officeart/2005/8/layout/hierarchy1"/>
    <dgm:cxn modelId="{2866FC99-9D56-8749-9981-2C266E72A548}" type="presParOf" srcId="{37DE4C55-618F-684F-9CB8-1E8860CA5155}" destId="{F8E4BBC7-2FB8-5249-8FE4-AAEFA56BAA33}" srcOrd="1" destOrd="0" presId="urn:microsoft.com/office/officeart/2005/8/layout/hierarchy1"/>
    <dgm:cxn modelId="{98FC8511-E2F6-DA4D-8C89-476D028CA828}" type="presParOf" srcId="{EF841757-C87C-A04E-9831-996D63CAA670}" destId="{D5577A34-4E0A-2940-953B-3DC98B23D46F}" srcOrd="1" destOrd="0" presId="urn:microsoft.com/office/officeart/2005/8/layout/hierarchy1"/>
    <dgm:cxn modelId="{6529C2C0-BAF6-F34C-B1DF-610D7559CF4D}" type="presParOf" srcId="{03E7E43E-119B-5943-A84E-DD295EE2B47B}" destId="{F6894DF5-5879-8348-A4F8-8962C62FA8A1}" srcOrd="2" destOrd="0" presId="urn:microsoft.com/office/officeart/2005/8/layout/hierarchy1"/>
    <dgm:cxn modelId="{0EE15E4C-2CAE-1844-BE60-942BFE3FE855}" type="presParOf" srcId="{03E7E43E-119B-5943-A84E-DD295EE2B47B}" destId="{1E2F4A4F-C582-394D-9E55-478AACEB8D0D}" srcOrd="3" destOrd="0" presId="urn:microsoft.com/office/officeart/2005/8/layout/hierarchy1"/>
    <dgm:cxn modelId="{8D1E7D04-B465-EE46-AF83-D753FFF33CA5}" type="presParOf" srcId="{1E2F4A4F-C582-394D-9E55-478AACEB8D0D}" destId="{42FC6C98-F283-634F-A227-EEBC52D8590A}" srcOrd="0" destOrd="0" presId="urn:microsoft.com/office/officeart/2005/8/layout/hierarchy1"/>
    <dgm:cxn modelId="{D4F1F3DC-84BF-0348-BE29-F9659245FB3B}" type="presParOf" srcId="{42FC6C98-F283-634F-A227-EEBC52D8590A}" destId="{7AB9D9A2-2BBA-1C4C-8772-F0BAFAD723AF}" srcOrd="0" destOrd="0" presId="urn:microsoft.com/office/officeart/2005/8/layout/hierarchy1"/>
    <dgm:cxn modelId="{6E0FCBE4-4184-5C42-9BD6-0062DB9DE053}" type="presParOf" srcId="{42FC6C98-F283-634F-A227-EEBC52D8590A}" destId="{F1685F0A-F0A9-8B43-9539-C84DC742ED62}" srcOrd="1" destOrd="0" presId="urn:microsoft.com/office/officeart/2005/8/layout/hierarchy1"/>
    <dgm:cxn modelId="{413D0994-684A-434C-9D6D-FE230195EA93}" type="presParOf" srcId="{1E2F4A4F-C582-394D-9E55-478AACEB8D0D}" destId="{B1EA03FD-8093-6A4B-96BE-241FD5AE7401}" srcOrd="1" destOrd="0" presId="urn:microsoft.com/office/officeart/2005/8/layout/hierarchy1"/>
    <dgm:cxn modelId="{98BD1B27-4DF5-2F45-BAA3-7D2DD1E8BA52}" type="presParOf" srcId="{03E7E43E-119B-5943-A84E-DD295EE2B47B}" destId="{D7BDF67D-8FA6-AC4C-9D04-66B81F6A13C0}" srcOrd="4" destOrd="0" presId="urn:microsoft.com/office/officeart/2005/8/layout/hierarchy1"/>
    <dgm:cxn modelId="{E33725BF-ADA6-DA4C-A5E4-1F2775B455FF}" type="presParOf" srcId="{03E7E43E-119B-5943-A84E-DD295EE2B47B}" destId="{C01AA11B-6A68-9644-9E08-D5FC7AF827B6}" srcOrd="5" destOrd="0" presId="urn:microsoft.com/office/officeart/2005/8/layout/hierarchy1"/>
    <dgm:cxn modelId="{8FB476EA-BB47-A246-B61E-4CD807DB8535}" type="presParOf" srcId="{C01AA11B-6A68-9644-9E08-D5FC7AF827B6}" destId="{C09C9089-550C-8949-8A35-67646A240D73}" srcOrd="0" destOrd="0" presId="urn:microsoft.com/office/officeart/2005/8/layout/hierarchy1"/>
    <dgm:cxn modelId="{0E352AD3-F871-ED49-A348-64FDB458512B}" type="presParOf" srcId="{C09C9089-550C-8949-8A35-67646A240D73}" destId="{90D22B4D-18AA-4A4A-8C86-C9FFBD9FF26A}" srcOrd="0" destOrd="0" presId="urn:microsoft.com/office/officeart/2005/8/layout/hierarchy1"/>
    <dgm:cxn modelId="{53E9AEEE-512A-9C48-8EFA-EF3E1F1A8C10}" type="presParOf" srcId="{C09C9089-550C-8949-8A35-67646A240D73}" destId="{0A13A63A-DD07-304B-AC89-92A52D8A5BD0}" srcOrd="1" destOrd="0" presId="urn:microsoft.com/office/officeart/2005/8/layout/hierarchy1"/>
    <dgm:cxn modelId="{5C2EC152-4C0B-B74B-B0D9-893211EF6127}" type="presParOf" srcId="{C01AA11B-6A68-9644-9E08-D5FC7AF827B6}" destId="{4FF8D54C-E47C-7548-AF99-35CE3860B0B8}" srcOrd="1" destOrd="0" presId="urn:microsoft.com/office/officeart/2005/8/layout/hierarchy1"/>
    <dgm:cxn modelId="{1A57FC92-3575-084C-AAD1-6478B53B5B88}" type="presParOf" srcId="{03E7E43E-119B-5943-A84E-DD295EE2B47B}" destId="{446F4E67-88BC-7A43-A852-CC883EE6C715}" srcOrd="6" destOrd="0" presId="urn:microsoft.com/office/officeart/2005/8/layout/hierarchy1"/>
    <dgm:cxn modelId="{7EC33E72-B5BC-B340-9275-5C41EF4D508D}" type="presParOf" srcId="{03E7E43E-119B-5943-A84E-DD295EE2B47B}" destId="{B8853746-F6D4-A540-A975-6A1326568EAA}" srcOrd="7" destOrd="0" presId="urn:microsoft.com/office/officeart/2005/8/layout/hierarchy1"/>
    <dgm:cxn modelId="{321757AF-27C1-B84E-A523-CA877039FB76}" type="presParOf" srcId="{B8853746-F6D4-A540-A975-6A1326568EAA}" destId="{15BC839D-D2F8-E24D-9741-4E6B19970502}" srcOrd="0" destOrd="0" presId="urn:microsoft.com/office/officeart/2005/8/layout/hierarchy1"/>
    <dgm:cxn modelId="{2E0607B0-16FD-1543-BD01-3EC281E6A992}" type="presParOf" srcId="{15BC839D-D2F8-E24D-9741-4E6B19970502}" destId="{53F44CD7-C445-234E-9598-74EA875913BD}" srcOrd="0" destOrd="0" presId="urn:microsoft.com/office/officeart/2005/8/layout/hierarchy1"/>
    <dgm:cxn modelId="{E29F57BB-C698-9A4E-8D70-2D410E11B7A5}" type="presParOf" srcId="{15BC839D-D2F8-E24D-9741-4E6B19970502}" destId="{96AF6CF4-C09F-E040-87E9-710D41D36CF8}" srcOrd="1" destOrd="0" presId="urn:microsoft.com/office/officeart/2005/8/layout/hierarchy1"/>
    <dgm:cxn modelId="{F2D9A5DB-52BD-504A-9EFA-598A1E3B9934}" type="presParOf" srcId="{B8853746-F6D4-A540-A975-6A1326568EAA}" destId="{3433FC5F-FE51-5040-8A04-3F9AFE7D77E3}" srcOrd="1" destOrd="0" presId="urn:microsoft.com/office/officeart/2005/8/layout/hierarchy1"/>
    <dgm:cxn modelId="{D2893044-BC4E-464F-99C1-72E6B71AC1FA}" type="presParOf" srcId="{3433FC5F-FE51-5040-8A04-3F9AFE7D77E3}" destId="{A33D5B56-0EA0-D945-B658-4D3F3A77EEDD}" srcOrd="0" destOrd="0" presId="urn:microsoft.com/office/officeart/2005/8/layout/hierarchy1"/>
    <dgm:cxn modelId="{BAD69B1F-A90A-5846-8C46-19FCA8511913}" type="presParOf" srcId="{3433FC5F-FE51-5040-8A04-3F9AFE7D77E3}" destId="{F47B2FC4-6282-2C42-9DDD-04D1E52FD223}" srcOrd="1" destOrd="0" presId="urn:microsoft.com/office/officeart/2005/8/layout/hierarchy1"/>
    <dgm:cxn modelId="{7D94E8ED-C21C-6549-A8A4-13B61366DCFA}" type="presParOf" srcId="{F47B2FC4-6282-2C42-9DDD-04D1E52FD223}" destId="{57BEAB95-2E6F-8C49-8373-7EDC976931F9}" srcOrd="0" destOrd="0" presId="urn:microsoft.com/office/officeart/2005/8/layout/hierarchy1"/>
    <dgm:cxn modelId="{75AFC03C-C98C-5A43-AB13-88BD3587E6AB}" type="presParOf" srcId="{57BEAB95-2E6F-8C49-8373-7EDC976931F9}" destId="{5477B4F8-B591-D147-B879-3D0CC6329F19}" srcOrd="0" destOrd="0" presId="urn:microsoft.com/office/officeart/2005/8/layout/hierarchy1"/>
    <dgm:cxn modelId="{70DC9663-08DB-7A4B-AB20-EE89FE2A8ED3}" type="presParOf" srcId="{57BEAB95-2E6F-8C49-8373-7EDC976931F9}" destId="{2DC3A4D2-4B36-AA48-A363-EF5FAB102D0B}" srcOrd="1" destOrd="0" presId="urn:microsoft.com/office/officeart/2005/8/layout/hierarchy1"/>
    <dgm:cxn modelId="{8808D300-2F94-A646-BA14-F2B5FA951050}" type="presParOf" srcId="{F47B2FC4-6282-2C42-9DDD-04D1E52FD223}" destId="{D8402163-8307-C34F-988A-69311C8FCC53}" srcOrd="1" destOrd="0" presId="urn:microsoft.com/office/officeart/2005/8/layout/hierarchy1"/>
    <dgm:cxn modelId="{0A58124C-4E9C-404E-99EC-860B7585231C}" type="presParOf" srcId="{3433FC5F-FE51-5040-8A04-3F9AFE7D77E3}" destId="{D7586BF2-31A1-0147-AA53-A1D6B571A49E}" srcOrd="2" destOrd="0" presId="urn:microsoft.com/office/officeart/2005/8/layout/hierarchy1"/>
    <dgm:cxn modelId="{96D612CC-B0BB-9142-9863-60024D8F17E9}" type="presParOf" srcId="{3433FC5F-FE51-5040-8A04-3F9AFE7D77E3}" destId="{CDC46534-D13E-4242-B60C-2CC33E6682B4}" srcOrd="3" destOrd="0" presId="urn:microsoft.com/office/officeart/2005/8/layout/hierarchy1"/>
    <dgm:cxn modelId="{A9A02023-0FF4-884B-9F7A-61F5BB6E9E65}" type="presParOf" srcId="{CDC46534-D13E-4242-B60C-2CC33E6682B4}" destId="{656FC198-09F4-8B43-98FB-BB98F42F907F}" srcOrd="0" destOrd="0" presId="urn:microsoft.com/office/officeart/2005/8/layout/hierarchy1"/>
    <dgm:cxn modelId="{BFEAA590-4CA0-2542-A83F-8C4DC55708B1}" type="presParOf" srcId="{656FC198-09F4-8B43-98FB-BB98F42F907F}" destId="{3349BB63-9067-664C-BA08-3C773FA89C23}" srcOrd="0" destOrd="0" presId="urn:microsoft.com/office/officeart/2005/8/layout/hierarchy1"/>
    <dgm:cxn modelId="{E7410776-1361-524E-A4D7-51752F4976EE}" type="presParOf" srcId="{656FC198-09F4-8B43-98FB-BB98F42F907F}" destId="{729A0B73-F774-B24C-9D96-22BE41F788A2}" srcOrd="1" destOrd="0" presId="urn:microsoft.com/office/officeart/2005/8/layout/hierarchy1"/>
    <dgm:cxn modelId="{F158EF10-7A3A-7A4B-B07D-1A0230D0AACF}" type="presParOf" srcId="{CDC46534-D13E-4242-B60C-2CC33E6682B4}" destId="{8FDF5380-2820-7F40-8C56-99933729CBAE}" srcOrd="1" destOrd="0" presId="urn:microsoft.com/office/officeart/2005/8/layout/hierarchy1"/>
    <dgm:cxn modelId="{89BE55D8-8A99-2249-A055-A82AFAA6062A}" type="presParOf" srcId="{3433FC5F-FE51-5040-8A04-3F9AFE7D77E3}" destId="{D9113A05-D511-1F40-929D-719CA4232259}" srcOrd="4" destOrd="0" presId="urn:microsoft.com/office/officeart/2005/8/layout/hierarchy1"/>
    <dgm:cxn modelId="{7108BCB7-6525-3A46-821E-EDCFCFEE7E57}" type="presParOf" srcId="{3433FC5F-FE51-5040-8A04-3F9AFE7D77E3}" destId="{7706DEC9-72A2-2E4D-A873-294A51CE315A}" srcOrd="5" destOrd="0" presId="urn:microsoft.com/office/officeart/2005/8/layout/hierarchy1"/>
    <dgm:cxn modelId="{57EA65BC-9690-5749-BF62-FA2E73846B92}" type="presParOf" srcId="{7706DEC9-72A2-2E4D-A873-294A51CE315A}" destId="{CD6ADB72-69B0-6842-863C-CB02822ACEE6}" srcOrd="0" destOrd="0" presId="urn:microsoft.com/office/officeart/2005/8/layout/hierarchy1"/>
    <dgm:cxn modelId="{FCE71EA1-0845-DC4A-B2B0-B2A2EEDD75AE}" type="presParOf" srcId="{CD6ADB72-69B0-6842-863C-CB02822ACEE6}" destId="{2DC54CE6-DEBF-724A-9187-9C34D64926B2}" srcOrd="0" destOrd="0" presId="urn:microsoft.com/office/officeart/2005/8/layout/hierarchy1"/>
    <dgm:cxn modelId="{76E9448D-3A06-8B49-9F31-B3C4972FFA00}" type="presParOf" srcId="{CD6ADB72-69B0-6842-863C-CB02822ACEE6}" destId="{67614E9A-406B-FD4F-9E39-9520F5A91A83}" srcOrd="1" destOrd="0" presId="urn:microsoft.com/office/officeart/2005/8/layout/hierarchy1"/>
    <dgm:cxn modelId="{34E25943-F2FA-F24D-9933-5ECA3F4E1D79}" type="presParOf" srcId="{7706DEC9-72A2-2E4D-A873-294A51CE315A}" destId="{040B232D-61DF-4042-AEAE-D462D1A96720}" srcOrd="1" destOrd="0" presId="urn:microsoft.com/office/officeart/2005/8/layout/hierarchy1"/>
    <dgm:cxn modelId="{DE0BAFB4-3241-B341-AC95-2FC8DF38FE92}" type="presParOf" srcId="{90F8035B-03D8-AD46-907A-1A03E737D959}" destId="{32679EFE-854F-F941-8FE3-C13B60CB7216}" srcOrd="2" destOrd="0" presId="urn:microsoft.com/office/officeart/2005/8/layout/hierarchy1"/>
    <dgm:cxn modelId="{24D02BD2-45E6-0444-9AD0-A11CD5052C3A}" type="presParOf" srcId="{90F8035B-03D8-AD46-907A-1A03E737D959}" destId="{3AAC2DF9-B421-FC46-81F3-FAEF9E132194}" srcOrd="3" destOrd="0" presId="urn:microsoft.com/office/officeart/2005/8/layout/hierarchy1"/>
    <dgm:cxn modelId="{DABC17DF-B3E5-AB41-AE3B-A72F292BC13F}" type="presParOf" srcId="{3AAC2DF9-B421-FC46-81F3-FAEF9E132194}" destId="{9C49EE25-388F-984C-9FFD-A6CBD2567834}" srcOrd="0" destOrd="0" presId="urn:microsoft.com/office/officeart/2005/8/layout/hierarchy1"/>
    <dgm:cxn modelId="{4507CD7C-CC22-FD49-82E7-35A283E47CFD}" type="presParOf" srcId="{9C49EE25-388F-984C-9FFD-A6CBD2567834}" destId="{8E02BD0C-9C2C-C640-9256-674102800903}" srcOrd="0" destOrd="0" presId="urn:microsoft.com/office/officeart/2005/8/layout/hierarchy1"/>
    <dgm:cxn modelId="{59E8F301-F61B-2B4A-9815-071D8509E396}" type="presParOf" srcId="{9C49EE25-388F-984C-9FFD-A6CBD2567834}" destId="{0736A4EC-7AD2-754B-9EB3-AA700478FD72}" srcOrd="1" destOrd="0" presId="urn:microsoft.com/office/officeart/2005/8/layout/hierarchy1"/>
    <dgm:cxn modelId="{1BCC52AF-0536-5745-9ADC-A0898D6C47B0}" type="presParOf" srcId="{3AAC2DF9-B421-FC46-81F3-FAEF9E132194}" destId="{FA5901C7-AFEC-B548-A33B-BC1F17D68908}" srcOrd="1" destOrd="0" presId="urn:microsoft.com/office/officeart/2005/8/layout/hierarchy1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32679EFE-854F-F941-8FE3-C13B60CB7216}">
      <dsp:nvSpPr>
        <dsp:cNvPr id="0" name=""/>
        <dsp:cNvSpPr/>
      </dsp:nvSpPr>
      <dsp:spPr>
        <a:xfrm>
          <a:off x="3416459" y="1390303"/>
          <a:ext cx="586884" cy="279303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90337"/>
              </a:lnTo>
              <a:lnTo>
                <a:pt x="586884" y="190337"/>
              </a:lnTo>
              <a:lnTo>
                <a:pt x="586884" y="279303"/>
              </a:lnTo>
            </a:path>
          </a:pathLst>
        </a:custGeom>
        <a:noFill/>
        <a:ln w="25400" cap="flat" cmpd="sng" algn="ctr">
          <a:solidFill>
            <a:schemeClr val="accent3">
              <a:shade val="6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D9113A05-D511-1F40-929D-719CA4232259}">
      <dsp:nvSpPr>
        <dsp:cNvPr id="0" name=""/>
        <dsp:cNvSpPr/>
      </dsp:nvSpPr>
      <dsp:spPr>
        <a:xfrm>
          <a:off x="4590227" y="3168562"/>
          <a:ext cx="1173768" cy="279303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90337"/>
              </a:lnTo>
              <a:lnTo>
                <a:pt x="1173768" y="190337"/>
              </a:lnTo>
              <a:lnTo>
                <a:pt x="1173768" y="279303"/>
              </a:lnTo>
            </a:path>
          </a:pathLst>
        </a:custGeom>
        <a:noFill/>
        <a:ln w="25400" cap="flat" cmpd="sng" algn="ctr">
          <a:solidFill>
            <a:schemeClr val="accent3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D7586BF2-31A1-0147-AA53-A1D6B571A49E}">
      <dsp:nvSpPr>
        <dsp:cNvPr id="0" name=""/>
        <dsp:cNvSpPr/>
      </dsp:nvSpPr>
      <dsp:spPr>
        <a:xfrm>
          <a:off x="4544507" y="3168562"/>
          <a:ext cx="91440" cy="279303"/>
        </a:xfrm>
        <a:custGeom>
          <a:avLst/>
          <a:gdLst/>
          <a:ahLst/>
          <a:cxnLst/>
          <a:rect l="0" t="0" r="0" b="0"/>
          <a:pathLst>
            <a:path>
              <a:moveTo>
                <a:pt x="45720" y="0"/>
              </a:moveTo>
              <a:lnTo>
                <a:pt x="45720" y="279303"/>
              </a:lnTo>
            </a:path>
          </a:pathLst>
        </a:custGeom>
        <a:noFill/>
        <a:ln w="25400" cap="flat" cmpd="sng" algn="ctr">
          <a:solidFill>
            <a:schemeClr val="accent3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A33D5B56-0EA0-D945-B658-4D3F3A77EEDD}">
      <dsp:nvSpPr>
        <dsp:cNvPr id="0" name=""/>
        <dsp:cNvSpPr/>
      </dsp:nvSpPr>
      <dsp:spPr>
        <a:xfrm>
          <a:off x="3416459" y="3168562"/>
          <a:ext cx="1173768" cy="279303"/>
        </a:xfrm>
        <a:custGeom>
          <a:avLst/>
          <a:gdLst/>
          <a:ahLst/>
          <a:cxnLst/>
          <a:rect l="0" t="0" r="0" b="0"/>
          <a:pathLst>
            <a:path>
              <a:moveTo>
                <a:pt x="1173768" y="0"/>
              </a:moveTo>
              <a:lnTo>
                <a:pt x="1173768" y="190337"/>
              </a:lnTo>
              <a:lnTo>
                <a:pt x="0" y="190337"/>
              </a:lnTo>
              <a:lnTo>
                <a:pt x="0" y="279303"/>
              </a:lnTo>
            </a:path>
          </a:pathLst>
        </a:custGeom>
        <a:noFill/>
        <a:ln w="25400" cap="flat" cmpd="sng" algn="ctr">
          <a:solidFill>
            <a:schemeClr val="accent3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446F4E67-88BC-7A43-A852-CC883EE6C715}">
      <dsp:nvSpPr>
        <dsp:cNvPr id="0" name=""/>
        <dsp:cNvSpPr/>
      </dsp:nvSpPr>
      <dsp:spPr>
        <a:xfrm>
          <a:off x="2829575" y="2279433"/>
          <a:ext cx="1760652" cy="279303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90337"/>
              </a:lnTo>
              <a:lnTo>
                <a:pt x="1760652" y="190337"/>
              </a:lnTo>
              <a:lnTo>
                <a:pt x="1760652" y="279303"/>
              </a:lnTo>
            </a:path>
          </a:pathLst>
        </a:custGeom>
        <a:noFill/>
        <a:ln w="25400" cap="flat" cmpd="sng" algn="ctr">
          <a:solidFill>
            <a:schemeClr val="accent3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D7BDF67D-8FA6-AC4C-9D04-66B81F6A13C0}">
      <dsp:nvSpPr>
        <dsp:cNvPr id="0" name=""/>
        <dsp:cNvSpPr/>
      </dsp:nvSpPr>
      <dsp:spPr>
        <a:xfrm>
          <a:off x="2829575" y="2279433"/>
          <a:ext cx="586884" cy="279303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90337"/>
              </a:lnTo>
              <a:lnTo>
                <a:pt x="586884" y="190337"/>
              </a:lnTo>
              <a:lnTo>
                <a:pt x="586884" y="279303"/>
              </a:lnTo>
            </a:path>
          </a:pathLst>
        </a:custGeom>
        <a:noFill/>
        <a:ln w="25400" cap="flat" cmpd="sng" algn="ctr">
          <a:solidFill>
            <a:schemeClr val="accent3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F6894DF5-5879-8348-A4F8-8962C62FA8A1}">
      <dsp:nvSpPr>
        <dsp:cNvPr id="0" name=""/>
        <dsp:cNvSpPr/>
      </dsp:nvSpPr>
      <dsp:spPr>
        <a:xfrm>
          <a:off x="2242691" y="2279433"/>
          <a:ext cx="586884" cy="279303"/>
        </a:xfrm>
        <a:custGeom>
          <a:avLst/>
          <a:gdLst/>
          <a:ahLst/>
          <a:cxnLst/>
          <a:rect l="0" t="0" r="0" b="0"/>
          <a:pathLst>
            <a:path>
              <a:moveTo>
                <a:pt x="586884" y="0"/>
              </a:moveTo>
              <a:lnTo>
                <a:pt x="586884" y="190337"/>
              </a:lnTo>
              <a:lnTo>
                <a:pt x="0" y="190337"/>
              </a:lnTo>
              <a:lnTo>
                <a:pt x="0" y="279303"/>
              </a:lnTo>
            </a:path>
          </a:pathLst>
        </a:custGeom>
        <a:noFill/>
        <a:ln w="25400" cap="flat" cmpd="sng" algn="ctr">
          <a:solidFill>
            <a:schemeClr val="accent3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D260344F-5A95-5648-845B-B731997D3E5E}">
      <dsp:nvSpPr>
        <dsp:cNvPr id="0" name=""/>
        <dsp:cNvSpPr/>
      </dsp:nvSpPr>
      <dsp:spPr>
        <a:xfrm>
          <a:off x="1068923" y="3168562"/>
          <a:ext cx="586884" cy="279303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90337"/>
              </a:lnTo>
              <a:lnTo>
                <a:pt x="586884" y="190337"/>
              </a:lnTo>
              <a:lnTo>
                <a:pt x="586884" y="279303"/>
              </a:lnTo>
            </a:path>
          </a:pathLst>
        </a:custGeom>
        <a:noFill/>
        <a:ln w="25400" cap="flat" cmpd="sng" algn="ctr">
          <a:solidFill>
            <a:schemeClr val="accent3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213951CC-5EE6-A447-AB59-5EDED21D8883}">
      <dsp:nvSpPr>
        <dsp:cNvPr id="0" name=""/>
        <dsp:cNvSpPr/>
      </dsp:nvSpPr>
      <dsp:spPr>
        <a:xfrm>
          <a:off x="482039" y="3168562"/>
          <a:ext cx="586884" cy="279303"/>
        </a:xfrm>
        <a:custGeom>
          <a:avLst/>
          <a:gdLst/>
          <a:ahLst/>
          <a:cxnLst/>
          <a:rect l="0" t="0" r="0" b="0"/>
          <a:pathLst>
            <a:path>
              <a:moveTo>
                <a:pt x="586884" y="0"/>
              </a:moveTo>
              <a:lnTo>
                <a:pt x="586884" y="190337"/>
              </a:lnTo>
              <a:lnTo>
                <a:pt x="0" y="190337"/>
              </a:lnTo>
              <a:lnTo>
                <a:pt x="0" y="279303"/>
              </a:lnTo>
            </a:path>
          </a:pathLst>
        </a:custGeom>
        <a:noFill/>
        <a:ln w="25400" cap="flat" cmpd="sng" algn="ctr">
          <a:solidFill>
            <a:schemeClr val="accent3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43F0D894-3CB7-8E4A-BB5E-126E2F3532AD}">
      <dsp:nvSpPr>
        <dsp:cNvPr id="0" name=""/>
        <dsp:cNvSpPr/>
      </dsp:nvSpPr>
      <dsp:spPr>
        <a:xfrm>
          <a:off x="1068923" y="2279433"/>
          <a:ext cx="1760652" cy="279303"/>
        </a:xfrm>
        <a:custGeom>
          <a:avLst/>
          <a:gdLst/>
          <a:ahLst/>
          <a:cxnLst/>
          <a:rect l="0" t="0" r="0" b="0"/>
          <a:pathLst>
            <a:path>
              <a:moveTo>
                <a:pt x="1760652" y="0"/>
              </a:moveTo>
              <a:lnTo>
                <a:pt x="1760652" y="190337"/>
              </a:lnTo>
              <a:lnTo>
                <a:pt x="0" y="190337"/>
              </a:lnTo>
              <a:lnTo>
                <a:pt x="0" y="279303"/>
              </a:lnTo>
            </a:path>
          </a:pathLst>
        </a:custGeom>
        <a:noFill/>
        <a:ln w="25400" cap="flat" cmpd="sng" algn="ctr">
          <a:solidFill>
            <a:schemeClr val="accent3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B75598F6-28B6-C946-8DC9-47B1DB254A8D}">
      <dsp:nvSpPr>
        <dsp:cNvPr id="0" name=""/>
        <dsp:cNvSpPr/>
      </dsp:nvSpPr>
      <dsp:spPr>
        <a:xfrm>
          <a:off x="2829575" y="1390303"/>
          <a:ext cx="586884" cy="279303"/>
        </a:xfrm>
        <a:custGeom>
          <a:avLst/>
          <a:gdLst/>
          <a:ahLst/>
          <a:cxnLst/>
          <a:rect l="0" t="0" r="0" b="0"/>
          <a:pathLst>
            <a:path>
              <a:moveTo>
                <a:pt x="586884" y="0"/>
              </a:moveTo>
              <a:lnTo>
                <a:pt x="586884" y="190337"/>
              </a:lnTo>
              <a:lnTo>
                <a:pt x="0" y="190337"/>
              </a:lnTo>
              <a:lnTo>
                <a:pt x="0" y="279303"/>
              </a:lnTo>
            </a:path>
          </a:pathLst>
        </a:custGeom>
        <a:noFill/>
        <a:ln w="25400" cap="flat" cmpd="sng" algn="ctr">
          <a:solidFill>
            <a:schemeClr val="accent3">
              <a:shade val="6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C5564295-A2F9-7942-BA6B-4539318F13D7}">
      <dsp:nvSpPr>
        <dsp:cNvPr id="0" name=""/>
        <dsp:cNvSpPr/>
      </dsp:nvSpPr>
      <dsp:spPr>
        <a:xfrm>
          <a:off x="2936281" y="780478"/>
          <a:ext cx="960355" cy="609825"/>
        </a:xfrm>
        <a:prstGeom prst="roundRect">
          <a:avLst>
            <a:gd name="adj" fmla="val 10000"/>
          </a:avLst>
        </a:prstGeom>
        <a:solidFill>
          <a:schemeClr val="accent3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B4B20D3A-DB79-A241-812A-2A7BBD374565}">
      <dsp:nvSpPr>
        <dsp:cNvPr id="0" name=""/>
        <dsp:cNvSpPr/>
      </dsp:nvSpPr>
      <dsp:spPr>
        <a:xfrm>
          <a:off x="3042987" y="881848"/>
          <a:ext cx="960355" cy="609825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3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b="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biological processes</a:t>
          </a:r>
        </a:p>
      </dsp:txBody>
      <dsp:txXfrm>
        <a:off x="3060848" y="899709"/>
        <a:ext cx="924633" cy="574103"/>
      </dsp:txXfrm>
    </dsp:sp>
    <dsp:sp modelId="{2B146940-E059-2944-BF65-EA87FD688AC9}">
      <dsp:nvSpPr>
        <dsp:cNvPr id="0" name=""/>
        <dsp:cNvSpPr/>
      </dsp:nvSpPr>
      <dsp:spPr>
        <a:xfrm>
          <a:off x="2349397" y="1669607"/>
          <a:ext cx="960355" cy="609825"/>
        </a:xfrm>
        <a:prstGeom prst="roundRect">
          <a:avLst>
            <a:gd name="adj" fmla="val 10000"/>
          </a:avLst>
        </a:prstGeom>
        <a:solidFill>
          <a:schemeClr val="accent3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CB3D9721-3020-4243-A708-C0096848BFE7}">
      <dsp:nvSpPr>
        <dsp:cNvPr id="0" name=""/>
        <dsp:cNvSpPr/>
      </dsp:nvSpPr>
      <dsp:spPr>
        <a:xfrm>
          <a:off x="2456103" y="1770978"/>
          <a:ext cx="960355" cy="609825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3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b="0" i="0" u="none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response to stimulus</a:t>
          </a:r>
          <a:endParaRPr lang="en-US" sz="1200" b="0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2473964" y="1788839"/>
        <a:ext cx="924633" cy="574103"/>
      </dsp:txXfrm>
    </dsp:sp>
    <dsp:sp modelId="{D63FB592-4930-8645-93AF-78380E5B956F}">
      <dsp:nvSpPr>
        <dsp:cNvPr id="0" name=""/>
        <dsp:cNvSpPr/>
      </dsp:nvSpPr>
      <dsp:spPr>
        <a:xfrm>
          <a:off x="588745" y="2558736"/>
          <a:ext cx="960355" cy="609825"/>
        </a:xfrm>
        <a:prstGeom prst="roundRect">
          <a:avLst>
            <a:gd name="adj" fmla="val 10000"/>
          </a:avLst>
        </a:prstGeom>
        <a:solidFill>
          <a:schemeClr val="accent3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9B1B7B8B-0937-D346-B0A2-EE588412136A}">
      <dsp:nvSpPr>
        <dsp:cNvPr id="0" name=""/>
        <dsp:cNvSpPr/>
      </dsp:nvSpPr>
      <dsp:spPr>
        <a:xfrm>
          <a:off x="695451" y="2660107"/>
          <a:ext cx="960355" cy="609825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3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b="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response to external stimulus</a:t>
          </a:r>
        </a:p>
      </dsp:txBody>
      <dsp:txXfrm>
        <a:off x="713312" y="2677968"/>
        <a:ext cx="924633" cy="574103"/>
      </dsp:txXfrm>
    </dsp:sp>
    <dsp:sp modelId="{2FE059E0-EAA8-7140-A252-53728EF3D74F}">
      <dsp:nvSpPr>
        <dsp:cNvPr id="0" name=""/>
        <dsp:cNvSpPr/>
      </dsp:nvSpPr>
      <dsp:spPr>
        <a:xfrm>
          <a:off x="1861" y="3447866"/>
          <a:ext cx="960355" cy="609825"/>
        </a:xfrm>
        <a:prstGeom prst="roundRect">
          <a:avLst>
            <a:gd name="adj" fmla="val 10000"/>
          </a:avLst>
        </a:prstGeom>
        <a:solidFill>
          <a:schemeClr val="accent3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E28126F7-ED8B-C144-9EE8-42BE1085838E}">
      <dsp:nvSpPr>
        <dsp:cNvPr id="0" name=""/>
        <dsp:cNvSpPr/>
      </dsp:nvSpPr>
      <dsp:spPr>
        <a:xfrm>
          <a:off x="108567" y="3549237"/>
          <a:ext cx="960355" cy="609825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3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b="0" kern="1200">
              <a:latin typeface="Times New Roman" panose="02020603050405020304" pitchFamily="18" charset="0"/>
              <a:cs typeface="Times New Roman" panose="02020603050405020304" pitchFamily="18" charset="0"/>
            </a:rPr>
            <a:t>response to external biotic stimulus</a:t>
          </a:r>
        </a:p>
      </dsp:txBody>
      <dsp:txXfrm>
        <a:off x="126428" y="3567098"/>
        <a:ext cx="924633" cy="574103"/>
      </dsp:txXfrm>
    </dsp:sp>
    <dsp:sp modelId="{BDCC261F-E1F0-2941-B8BD-7126ED66B10C}">
      <dsp:nvSpPr>
        <dsp:cNvPr id="0" name=""/>
        <dsp:cNvSpPr/>
      </dsp:nvSpPr>
      <dsp:spPr>
        <a:xfrm>
          <a:off x="1175629" y="3447866"/>
          <a:ext cx="960355" cy="609825"/>
        </a:xfrm>
        <a:prstGeom prst="roundRect">
          <a:avLst>
            <a:gd name="adj" fmla="val 10000"/>
          </a:avLst>
        </a:prstGeom>
        <a:solidFill>
          <a:schemeClr val="accent3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F8E4BBC7-2FB8-5249-8FE4-AAEFA56BAA33}">
      <dsp:nvSpPr>
        <dsp:cNvPr id="0" name=""/>
        <dsp:cNvSpPr/>
      </dsp:nvSpPr>
      <dsp:spPr>
        <a:xfrm>
          <a:off x="1282335" y="3549237"/>
          <a:ext cx="960355" cy="609825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3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b="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response to other organism</a:t>
          </a:r>
        </a:p>
      </dsp:txBody>
      <dsp:txXfrm>
        <a:off x="1300196" y="3567098"/>
        <a:ext cx="924633" cy="574103"/>
      </dsp:txXfrm>
    </dsp:sp>
    <dsp:sp modelId="{7AB9D9A2-2BBA-1C4C-8772-F0BAFAD723AF}">
      <dsp:nvSpPr>
        <dsp:cNvPr id="0" name=""/>
        <dsp:cNvSpPr/>
      </dsp:nvSpPr>
      <dsp:spPr>
        <a:xfrm>
          <a:off x="1762513" y="2558736"/>
          <a:ext cx="960355" cy="609825"/>
        </a:xfrm>
        <a:prstGeom prst="roundRect">
          <a:avLst>
            <a:gd name="adj" fmla="val 10000"/>
          </a:avLst>
        </a:prstGeom>
        <a:solidFill>
          <a:schemeClr val="accent3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F1685F0A-F0A9-8B43-9539-C84DC742ED62}">
      <dsp:nvSpPr>
        <dsp:cNvPr id="0" name=""/>
        <dsp:cNvSpPr/>
      </dsp:nvSpPr>
      <dsp:spPr>
        <a:xfrm>
          <a:off x="1869219" y="2660107"/>
          <a:ext cx="960355" cy="609825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3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b="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response to stress</a:t>
          </a:r>
        </a:p>
      </dsp:txBody>
      <dsp:txXfrm>
        <a:off x="1887080" y="2677968"/>
        <a:ext cx="924633" cy="574103"/>
      </dsp:txXfrm>
    </dsp:sp>
    <dsp:sp modelId="{90D22B4D-18AA-4A4A-8C86-C9FFBD9FF26A}">
      <dsp:nvSpPr>
        <dsp:cNvPr id="0" name=""/>
        <dsp:cNvSpPr/>
      </dsp:nvSpPr>
      <dsp:spPr>
        <a:xfrm>
          <a:off x="2936281" y="2558736"/>
          <a:ext cx="960355" cy="609825"/>
        </a:xfrm>
        <a:prstGeom prst="roundRect">
          <a:avLst>
            <a:gd name="adj" fmla="val 10000"/>
          </a:avLst>
        </a:prstGeom>
        <a:solidFill>
          <a:schemeClr val="accent3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0A13A63A-DD07-304B-AC89-92A52D8A5BD0}">
      <dsp:nvSpPr>
        <dsp:cNvPr id="0" name=""/>
        <dsp:cNvSpPr/>
      </dsp:nvSpPr>
      <dsp:spPr>
        <a:xfrm>
          <a:off x="3042987" y="2660107"/>
          <a:ext cx="960355" cy="609825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3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b="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response to endogenous stimulus</a:t>
          </a:r>
        </a:p>
      </dsp:txBody>
      <dsp:txXfrm>
        <a:off x="3060848" y="2677968"/>
        <a:ext cx="924633" cy="574103"/>
      </dsp:txXfrm>
    </dsp:sp>
    <dsp:sp modelId="{53F44CD7-C445-234E-9598-74EA875913BD}">
      <dsp:nvSpPr>
        <dsp:cNvPr id="0" name=""/>
        <dsp:cNvSpPr/>
      </dsp:nvSpPr>
      <dsp:spPr>
        <a:xfrm>
          <a:off x="4110049" y="2558736"/>
          <a:ext cx="960355" cy="609825"/>
        </a:xfrm>
        <a:prstGeom prst="roundRect">
          <a:avLst>
            <a:gd name="adj" fmla="val 10000"/>
          </a:avLst>
        </a:prstGeom>
        <a:solidFill>
          <a:schemeClr val="accent3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96AF6CF4-C09F-E040-87E9-710D41D36CF8}">
      <dsp:nvSpPr>
        <dsp:cNvPr id="0" name=""/>
        <dsp:cNvSpPr/>
      </dsp:nvSpPr>
      <dsp:spPr>
        <a:xfrm>
          <a:off x="4216755" y="2660107"/>
          <a:ext cx="960355" cy="609825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3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b="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Response to chemical</a:t>
          </a:r>
        </a:p>
      </dsp:txBody>
      <dsp:txXfrm>
        <a:off x="4234616" y="2677968"/>
        <a:ext cx="924633" cy="574103"/>
      </dsp:txXfrm>
    </dsp:sp>
    <dsp:sp modelId="{5477B4F8-B591-D147-B879-3D0CC6329F19}">
      <dsp:nvSpPr>
        <dsp:cNvPr id="0" name=""/>
        <dsp:cNvSpPr/>
      </dsp:nvSpPr>
      <dsp:spPr>
        <a:xfrm>
          <a:off x="2936281" y="3447866"/>
          <a:ext cx="960355" cy="609825"/>
        </a:xfrm>
        <a:prstGeom prst="roundRect">
          <a:avLst>
            <a:gd name="adj" fmla="val 10000"/>
          </a:avLst>
        </a:prstGeom>
        <a:solidFill>
          <a:schemeClr val="accent3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2DC3A4D2-4B36-AA48-A363-EF5FAB102D0B}">
      <dsp:nvSpPr>
        <dsp:cNvPr id="0" name=""/>
        <dsp:cNvSpPr/>
      </dsp:nvSpPr>
      <dsp:spPr>
        <a:xfrm>
          <a:off x="3042987" y="3549237"/>
          <a:ext cx="960355" cy="609825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3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b="0" i="0" u="none" kern="1200">
              <a:latin typeface="Times New Roman" panose="02020603050405020304" pitchFamily="18" charset="0"/>
              <a:cs typeface="Times New Roman" panose="02020603050405020304" pitchFamily="18" charset="0"/>
            </a:rPr>
            <a:t>response to acid chemical</a:t>
          </a:r>
          <a:endParaRPr lang="en-US" sz="1200" b="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3060848" y="3567098"/>
        <a:ext cx="924633" cy="574103"/>
      </dsp:txXfrm>
    </dsp:sp>
    <dsp:sp modelId="{3349BB63-9067-664C-BA08-3C773FA89C23}">
      <dsp:nvSpPr>
        <dsp:cNvPr id="0" name=""/>
        <dsp:cNvSpPr/>
      </dsp:nvSpPr>
      <dsp:spPr>
        <a:xfrm>
          <a:off x="4110049" y="3447866"/>
          <a:ext cx="960355" cy="609825"/>
        </a:xfrm>
        <a:prstGeom prst="roundRect">
          <a:avLst>
            <a:gd name="adj" fmla="val 10000"/>
          </a:avLst>
        </a:prstGeom>
        <a:solidFill>
          <a:schemeClr val="accent3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729A0B73-F774-B24C-9D96-22BE41F788A2}">
      <dsp:nvSpPr>
        <dsp:cNvPr id="0" name=""/>
        <dsp:cNvSpPr/>
      </dsp:nvSpPr>
      <dsp:spPr>
        <a:xfrm>
          <a:off x="4216755" y="3549237"/>
          <a:ext cx="960355" cy="609825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3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b="0" i="0" u="none" kern="1200">
              <a:latin typeface="Times New Roman" panose="02020603050405020304" pitchFamily="18" charset="0"/>
              <a:cs typeface="Times New Roman" panose="02020603050405020304" pitchFamily="18" charset="0"/>
            </a:rPr>
            <a:t>response to organic substance</a:t>
          </a:r>
          <a:endParaRPr lang="en-US" sz="1200" b="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4234616" y="3567098"/>
        <a:ext cx="924633" cy="574103"/>
      </dsp:txXfrm>
    </dsp:sp>
    <dsp:sp modelId="{2DC54CE6-DEBF-724A-9187-9C34D64926B2}">
      <dsp:nvSpPr>
        <dsp:cNvPr id="0" name=""/>
        <dsp:cNvSpPr/>
      </dsp:nvSpPr>
      <dsp:spPr>
        <a:xfrm>
          <a:off x="5283817" y="3447866"/>
          <a:ext cx="960355" cy="609825"/>
        </a:xfrm>
        <a:prstGeom prst="roundRect">
          <a:avLst>
            <a:gd name="adj" fmla="val 10000"/>
          </a:avLst>
        </a:prstGeom>
        <a:solidFill>
          <a:schemeClr val="accent3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67614E9A-406B-FD4F-9E39-9520F5A91A83}">
      <dsp:nvSpPr>
        <dsp:cNvPr id="0" name=""/>
        <dsp:cNvSpPr/>
      </dsp:nvSpPr>
      <dsp:spPr>
        <a:xfrm>
          <a:off x="5390524" y="3549237"/>
          <a:ext cx="960355" cy="609825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3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b="0" i="0" u="none" kern="1200">
              <a:latin typeface="Times New Roman" panose="02020603050405020304" pitchFamily="18" charset="0"/>
              <a:cs typeface="Times New Roman" panose="02020603050405020304" pitchFamily="18" charset="0"/>
            </a:rPr>
            <a:t>response to oxygen-containing compound</a:t>
          </a:r>
          <a:endParaRPr lang="en-US" sz="1200" b="0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5408385" y="3567098"/>
        <a:ext cx="924633" cy="574103"/>
      </dsp:txXfrm>
    </dsp:sp>
    <dsp:sp modelId="{8E02BD0C-9C2C-C640-9256-674102800903}">
      <dsp:nvSpPr>
        <dsp:cNvPr id="0" name=""/>
        <dsp:cNvSpPr/>
      </dsp:nvSpPr>
      <dsp:spPr>
        <a:xfrm>
          <a:off x="3523165" y="1669607"/>
          <a:ext cx="960355" cy="609825"/>
        </a:xfrm>
        <a:prstGeom prst="roundRect">
          <a:avLst>
            <a:gd name="adj" fmla="val 10000"/>
          </a:avLst>
        </a:prstGeom>
        <a:solidFill>
          <a:schemeClr val="accent3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0736A4EC-7AD2-754B-9EB3-AA700478FD72}">
      <dsp:nvSpPr>
        <dsp:cNvPr id="0" name=""/>
        <dsp:cNvSpPr/>
      </dsp:nvSpPr>
      <dsp:spPr>
        <a:xfrm>
          <a:off x="3629871" y="1770978"/>
          <a:ext cx="960355" cy="609825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3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b="0" i="0" u="none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multi-organism process</a:t>
          </a:r>
          <a:endParaRPr lang="en-US" sz="1200" b="0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3647732" y="1788839"/>
        <a:ext cx="924633" cy="574103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hierarchy1">
  <dgm:title val=""/>
  <dgm:desc val=""/>
  <dgm:catLst>
    <dgm:cat type="hierarchy" pri="20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</dgm:ptLst>
      <dgm:cxnLst>
        <dgm:cxn modelId="4" srcId="0" destId="1" srcOrd="0" destOrd="0"/>
        <dgm:cxn modelId="5" srcId="1" destId="2" srcOrd="0" destOrd="0"/>
        <dgm:cxn modelId="6" srcId="1" destId="3" srcOrd="1" destOrd="0"/>
        <dgm:cxn modelId="23" srcId="2" destId="21" srcOrd="0" destOrd="0"/>
        <dgm:cxn modelId="24" srcId="2" destId="22" srcOrd="1" destOrd="0"/>
        <dgm:cxn modelId="33" srcId="3" destId="31" srcOrd="0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12"/>
      </dgm:ptLst>
      <dgm:cxnLst>
        <dgm:cxn modelId="2" srcId="0" destId="1" srcOrd="0" destOrd="0"/>
        <dgm:cxn modelId="13" srcId="1" destId="11" srcOrd="0" destOrd="0"/>
        <dgm:cxn modelId="14" srcId="1" destId="1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21"/>
        <dgm:pt modelId="211"/>
        <dgm:pt modelId="3"/>
        <dgm:pt modelId="31"/>
        <dgm:pt modelId="311"/>
      </dgm:ptLst>
      <dgm:cxnLst>
        <dgm:cxn modelId="4" srcId="0" destId="1" srcOrd="0" destOrd="0"/>
        <dgm:cxn modelId="5" srcId="1" destId="2" srcOrd="0" destOrd="0"/>
        <dgm:cxn modelId="6" srcId="1" destId="3" srcOrd="1" destOrd="0"/>
        <dgm:cxn modelId="23" srcId="2" destId="21" srcOrd="0" destOrd="0"/>
        <dgm:cxn modelId="24" srcId="21" destId="211" srcOrd="0" destOrd="0"/>
        <dgm:cxn modelId="33" srcId="3" destId="31" srcOrd="0" destOrd="0"/>
        <dgm:cxn modelId="34" srcId="31" destId="311" srcOrd="0" destOrd="0"/>
      </dgm:cxnLst>
      <dgm:bg/>
      <dgm:whole/>
    </dgm:dataModel>
  </dgm:clrData>
  <dgm:layoutNode name="hierChild1">
    <dgm:varLst>
      <dgm:chPref val="1"/>
      <dgm:dir/>
      <dgm:animOne val="branch"/>
      <dgm:animLvl val="lvl"/>
      <dgm:resizeHandles/>
    </dgm:varLst>
    <dgm:choose name="Name0">
      <dgm:if name="Name1" func="var" arg="dir" op="equ" val="norm">
        <dgm:alg type="hierChild">
          <dgm:param type="linDir" val="fromL"/>
        </dgm:alg>
      </dgm:if>
      <dgm:else name="Name2">
        <dgm:alg type="hierChild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primFontSz" for="des" ptType="node" op="equ" val="65"/>
      <dgm:constr type="w" for="des" forName="composite" refType="w"/>
      <dgm:constr type="h" for="des" forName="composite" refType="w" refFor="des" refForName="composite" fact="0.667"/>
      <dgm:constr type="w" for="des" forName="composite2" refType="w" refFor="des" refForName="composite"/>
      <dgm:constr type="h" for="des" forName="composite2" refType="h" refFor="des" refForName="composite"/>
      <dgm:constr type="w" for="des" forName="composite3" refType="w" refFor="des" refForName="composite"/>
      <dgm:constr type="h" for="des" forName="composite3" refType="h" refFor="des" refForName="composite"/>
      <dgm:constr type="w" for="des" forName="composite4" refType="w" refFor="des" refForName="composite"/>
      <dgm:constr type="h" for="des" forName="composite4" refType="h" refFor="des" refForName="composite"/>
      <dgm:constr type="w" for="des" forName="composite5" refType="w" refFor="des" refForName="composite"/>
      <dgm:constr type="h" for="des" forName="composite5" refType="h" refFor="des" refForName="composite"/>
      <dgm:constr type="sibSp" refType="w" refFor="des" refForName="composite" fact="0.1"/>
      <dgm:constr type="sibSp" for="des" forName="hierChild2" refType="sibSp"/>
      <dgm:constr type="sibSp" for="des" forName="hierChild3" refType="sibSp"/>
      <dgm:constr type="sibSp" for="des" forName="hierChild4" refType="sibSp"/>
      <dgm:constr type="sibSp" for="des" forName="hierChild5" refType="sibSp"/>
      <dgm:constr type="sibSp" for="des" forName="hierChild6" refType="sibSp"/>
      <dgm:constr type="sp" for="des" forName="hierRoot1" refType="h" refFor="des" refForName="composite" fact="0.25"/>
      <dgm:constr type="sp" for="des" forName="hierRoot2" refType="sp" refFor="des" refForName="hierRoot1"/>
      <dgm:constr type="sp" for="des" forName="hierRoot3" refType="sp" refFor="des" refForName="hierRoot1"/>
      <dgm:constr type="sp" for="des" forName="hierRoot4" refType="sp" refFor="des" refForName="hierRoot1"/>
      <dgm:constr type="sp" for="des" forName="hierRoot5" refType="sp" refFor="des" refForName="hierRoot1"/>
    </dgm:constrLst>
    <dgm:ruleLst/>
    <dgm:forEach name="Name3" axis="ch">
      <dgm:forEach name="Name4" axis="self" ptType="node">
        <dgm:layoutNode name="hierRoot1">
          <dgm:alg type="hierRoot"/>
          <dgm:shape xmlns:r="http://schemas.openxmlformats.org/officeDocument/2006/relationships" r:blip="">
            <dgm:adjLst/>
          </dgm:shape>
          <dgm:presOf/>
          <dgm:constrLst>
            <dgm:constr type="bendDist" for="des" ptType="parTrans" refType="sp" fact="0.5"/>
          </dgm:constrLst>
          <dgm:ruleLst/>
          <dgm:layoutNode name="composite">
            <dgm:alg type="composite"/>
            <dgm:shape xmlns:r="http://schemas.openxmlformats.org/officeDocument/2006/relationships" r:blip="">
              <dgm:adjLst/>
            </dgm:shape>
            <dgm:presOf/>
            <dgm:constrLst>
              <dgm:constr type="w" for="ch" forName="background" refType="w" fact="0.9"/>
              <dgm:constr type="h" for="ch" forName="background" refType="w" refFor="ch" refForName="background" fact="0.635"/>
              <dgm:constr type="t" for="ch" forName="background"/>
              <dgm:constr type="l" for="ch" forName="background"/>
              <dgm:constr type="w" for="ch" forName="text" refType="w" fact="0.9"/>
              <dgm:constr type="h" for="ch" forName="text" refType="w" refFor="ch" refForName="text" fact="0.635"/>
              <dgm:constr type="t" for="ch" forName="text" refType="w" fact="0.095"/>
              <dgm:constr type="l" for="ch" forName="text" refType="w" fact="0.1"/>
            </dgm:constrLst>
            <dgm:ruleLst/>
            <dgm:layoutNode name="background" styleLbl="node0" moveWith="text">
              <dgm:alg type="sp"/>
              <dgm:shape xmlns:r="http://schemas.openxmlformats.org/officeDocument/2006/relationships" type="roundRect" r:blip="">
                <dgm:adjLst>
                  <dgm:adj idx="1" val="0.1"/>
                </dgm:adjLst>
              </dgm:shape>
              <dgm:presOf/>
              <dgm:constrLst/>
              <dgm:ruleLst/>
            </dgm:layoutNode>
            <dgm:layoutNode name="text" styleLbl="fgAcc0">
              <dgm:varLst>
                <dgm:chPref val="3"/>
              </dgm:varLst>
              <dgm:alg type="tx"/>
              <dgm:shape xmlns:r="http://schemas.openxmlformats.org/officeDocument/2006/relationships" type="roundRect" r:blip="">
                <dgm:adjLst>
                  <dgm:adj idx="1" val="0.1"/>
                </dgm:adjLst>
              </dgm:shape>
              <dgm:presOf axis="self"/>
              <dgm:constrLst>
                <dgm:constr type="tMarg" refType="primFontSz" fact="0.3"/>
                <dgm:constr type="bMarg" refType="primFontSz" fact="0.3"/>
                <dgm:constr type="lMarg" refType="primFontSz" fact="0.3"/>
                <dgm:constr type="rMarg" refType="primFontSz" fact="0.3"/>
              </dgm:constrLst>
              <dgm:ruleLst>
                <dgm:rule type="primFontSz" val="5" fact="NaN" max="NaN"/>
              </dgm:ruleLst>
            </dgm:layoutNode>
          </dgm:layoutNode>
          <dgm:layoutNode name="hierChild2">
            <dgm:choose name="Name5">
              <dgm:if name="Name6" func="var" arg="dir" op="equ" val="norm">
                <dgm:alg type="hierChild">
                  <dgm:param type="linDir" val="fromL"/>
                </dgm:alg>
              </dgm:if>
              <dgm:else name="Name7">
                <dgm:alg type="hierChild">
                  <dgm:param type="linDir" val="fromR"/>
                </dgm:alg>
              </dgm:else>
            </dgm:choose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Name8" axis="ch">
              <dgm:forEach name="Name9" axis="self" ptType="parTrans" cnt="1">
                <dgm:layoutNode name="Name10">
                  <dgm:alg type="conn">
                    <dgm:param type="dim" val="1D"/>
                    <dgm:param type="endSty" val="noArr"/>
                    <dgm:param type="connRout" val="bend"/>
                    <dgm:param type="bendPt" val="end"/>
                    <dgm:param type="begPts" val="bCtr"/>
                    <dgm:param type="endPts" val="tCtr"/>
                    <dgm:param type="srcNode" val="background"/>
                    <dgm:param type="dstNode" val="background2"/>
                  </dgm:alg>
                  <dgm:shape xmlns:r="http://schemas.openxmlformats.org/officeDocument/2006/relationships" type="conn" r:blip="" zOrderOff="-999">
                    <dgm:adjLst/>
                  </dgm:shape>
                  <dgm:presOf axis="self"/>
                  <dgm:constrLst>
                    <dgm:constr type="begPad"/>
                    <dgm:constr type="endPad"/>
                  </dgm:constrLst>
                  <dgm:ruleLst/>
                </dgm:layoutNode>
              </dgm:forEach>
              <dgm:forEach name="Name11" axis="self" ptType="node">
                <dgm:layoutNode name="hierRoot2">
                  <dgm:alg type="hierRoot"/>
                  <dgm:shape xmlns:r="http://schemas.openxmlformats.org/officeDocument/2006/relationships" r:blip="">
                    <dgm:adjLst/>
                  </dgm:shape>
                  <dgm:presOf/>
                  <dgm:constrLst>
                    <dgm:constr type="bendDist" for="des" ptType="parTrans" refType="sp" fact="0.5"/>
                  </dgm:constrLst>
                  <dgm:ruleLst/>
                  <dgm:layoutNode name="composite2">
                    <dgm:alg type="composite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w" for="ch" forName="background2" refType="w" fact="0.9"/>
                      <dgm:constr type="h" for="ch" forName="background2" refType="w" refFor="ch" refForName="background2" fact="0.635"/>
                      <dgm:constr type="t" for="ch" forName="background2"/>
                      <dgm:constr type="l" for="ch" forName="background2"/>
                      <dgm:constr type="w" for="ch" forName="text2" refType="w" fact="0.9"/>
                      <dgm:constr type="h" for="ch" forName="text2" refType="w" refFor="ch" refForName="text2" fact="0.635"/>
                      <dgm:constr type="t" for="ch" forName="text2" refType="w" fact="0.095"/>
                      <dgm:constr type="l" for="ch" forName="text2" refType="w" fact="0.1"/>
                    </dgm:constrLst>
                    <dgm:ruleLst/>
                    <dgm:layoutNode name="background2" moveWith="text2">
                      <dgm:alg type="sp"/>
                      <dgm:shape xmlns:r="http://schemas.openxmlformats.org/officeDocument/2006/relationships" type="roundRect" r:blip="">
                        <dgm:adjLst>
                          <dgm:adj idx="1" val="0.1"/>
                        </dgm:adjLst>
                      </dgm:shape>
                      <dgm:presOf/>
                      <dgm:constrLst/>
                      <dgm:ruleLst/>
                    </dgm:layoutNode>
                    <dgm:layoutNode name="text2" styleLbl="fgAcc2">
                      <dgm:varLst>
                        <dgm:chPref val="3"/>
                      </dgm:varLst>
                      <dgm:alg type="tx"/>
                      <dgm:shape xmlns:r="http://schemas.openxmlformats.org/officeDocument/2006/relationships" type="roundRect" r:blip="">
                        <dgm:adjLst>
                          <dgm:adj idx="1" val="0.1"/>
                        </dgm:adjLst>
                      </dgm:shape>
                      <dgm:presOf axis="self"/>
                      <dgm:constrLst>
                        <dgm:constr type="tMarg" refType="primFontSz" fact="0.3"/>
                        <dgm:constr type="bMarg" refType="primFontSz" fact="0.3"/>
                        <dgm:constr type="lMarg" refType="primFontSz" fact="0.3"/>
                        <dgm:constr type="rMarg" refType="primFontSz" fact="0.3"/>
                      </dgm:constrLst>
                      <dgm:ruleLst>
                        <dgm:rule type="primFontSz" val="5" fact="NaN" max="NaN"/>
                      </dgm:ruleLst>
                    </dgm:layoutNode>
                  </dgm:layoutNode>
                  <dgm:layoutNode name="hierChild3">
                    <dgm:choose name="Name12">
                      <dgm:if name="Name13" func="var" arg="dir" op="equ" val="norm">
                        <dgm:alg type="hierChild">
                          <dgm:param type="linDir" val="fromL"/>
                        </dgm:alg>
                      </dgm:if>
                      <dgm:else name="Name14">
                        <dgm:alg type="hierChild">
                          <dgm:param type="linDir" val="fromR"/>
                        </dgm:alg>
                      </dgm:else>
                    </dgm:choose>
                    <dgm:shape xmlns:r="http://schemas.openxmlformats.org/officeDocument/2006/relationships" r:blip="">
                      <dgm:adjLst/>
                    </dgm:shape>
                    <dgm:presOf/>
                    <dgm:constrLst/>
                    <dgm:ruleLst/>
                    <dgm:forEach name="Name15" axis="ch">
                      <dgm:forEach name="Name16" axis="self" ptType="parTrans" cnt="1">
                        <dgm:layoutNode name="Name17">
                          <dgm:alg type="conn">
                            <dgm:param type="dim" val="1D"/>
                            <dgm:param type="endSty" val="noArr"/>
                            <dgm:param type="connRout" val="bend"/>
                            <dgm:param type="bendPt" val="end"/>
                            <dgm:param type="begPts" val="bCtr"/>
                            <dgm:param type="endPts" val="tCtr"/>
                            <dgm:param type="srcNode" val="background2"/>
                            <dgm:param type="dstNode" val="background3"/>
                          </dgm:alg>
                          <dgm:shape xmlns:r="http://schemas.openxmlformats.org/officeDocument/2006/relationships" type="conn" r:blip="" zOrderOff="-999">
                            <dgm:adjLst/>
                          </dgm:shape>
                          <dgm:presOf axis="self"/>
                          <dgm:constrLst>
                            <dgm:constr type="begPad"/>
                            <dgm:constr type="endPad"/>
                          </dgm:constrLst>
                          <dgm:ruleLst/>
                        </dgm:layoutNode>
                      </dgm:forEach>
                      <dgm:forEach name="Name18" axis="self" ptType="node">
                        <dgm:layoutNode name="hierRoot3">
                          <dgm:alg type="hierRoot"/>
                          <dgm:shape xmlns:r="http://schemas.openxmlformats.org/officeDocument/2006/relationships" r:blip="">
                            <dgm:adjLst/>
                          </dgm:shape>
                          <dgm:presOf/>
                          <dgm:constrLst>
                            <dgm:constr type="bendDist" for="des" ptType="parTrans" refType="sp" fact="0.5"/>
                          </dgm:constrLst>
                          <dgm:ruleLst/>
                          <dgm:layoutNode name="composite3">
                            <dgm:alg type="composite"/>
                            <dgm:shape xmlns:r="http://schemas.openxmlformats.org/officeDocument/2006/relationships" r:blip="">
                              <dgm:adjLst/>
                            </dgm:shape>
                            <dgm:presOf/>
                            <dgm:constrLst>
                              <dgm:constr type="w" for="ch" forName="background3" refType="w" fact="0.9"/>
                              <dgm:constr type="h" for="ch" forName="background3" refType="w" refFor="ch" refForName="background3" fact="0.635"/>
                              <dgm:constr type="t" for="ch" forName="background3"/>
                              <dgm:constr type="l" for="ch" forName="background3"/>
                              <dgm:constr type="w" for="ch" forName="text3" refType="w" fact="0.9"/>
                              <dgm:constr type="h" for="ch" forName="text3" refType="w" refFor="ch" refForName="text3" fact="0.635"/>
                              <dgm:constr type="t" for="ch" forName="text3" refType="w" fact="0.095"/>
                              <dgm:constr type="l" for="ch" forName="text3" refType="w" fact="0.1"/>
                            </dgm:constrLst>
                            <dgm:ruleLst/>
                            <dgm:layoutNode name="background3" moveWith="text3">
                              <dgm:alg type="sp"/>
                              <dgm:shape xmlns:r="http://schemas.openxmlformats.org/officeDocument/2006/relationships" type="roundRect" r:blip="">
                                <dgm:adjLst>
                                  <dgm:adj idx="1" val="0.1"/>
                                </dgm:adjLst>
                              </dgm:shape>
                              <dgm:presOf/>
                              <dgm:constrLst/>
                              <dgm:ruleLst/>
                            </dgm:layoutNode>
                            <dgm:layoutNode name="text3" styleLbl="fgAcc3">
                              <dgm:varLst>
                                <dgm:chPref val="3"/>
                              </dgm:varLst>
                              <dgm:alg type="tx"/>
                              <dgm:shape xmlns:r="http://schemas.openxmlformats.org/officeDocument/2006/relationships" type="roundRect" r:blip="">
                                <dgm:adjLst>
                                  <dgm:adj idx="1" val="0.1"/>
                                </dgm:adjLst>
                              </dgm:shape>
                              <dgm:presOf axis="self"/>
                              <dgm:constrLst>
                                <dgm:constr type="tMarg" refType="primFontSz" fact="0.3"/>
                                <dgm:constr type="bMarg" refType="primFontSz" fact="0.3"/>
                                <dgm:constr type="lMarg" refType="primFontSz" fact="0.3"/>
                                <dgm:constr type="rMarg" refType="primFontSz" fact="0.3"/>
                              </dgm:constrLst>
                              <dgm:ruleLst>
                                <dgm:rule type="primFontSz" val="5" fact="NaN" max="NaN"/>
                              </dgm:ruleLst>
                            </dgm:layoutNode>
                          </dgm:layoutNode>
                          <dgm:layoutNode name="hierChild4">
                            <dgm:choose name="Name19">
                              <dgm:if name="Name20" func="var" arg="dir" op="equ" val="norm">
                                <dgm:alg type="hierChild">
                                  <dgm:param type="linDir" val="fromL"/>
                                </dgm:alg>
                              </dgm:if>
                              <dgm:else name="Name21">
                                <dgm:alg type="hierChild">
                                  <dgm:param type="linDir" val="fromR"/>
                                </dgm:alg>
                              </dgm:else>
                            </dgm:choose>
                            <dgm:shape xmlns:r="http://schemas.openxmlformats.org/officeDocument/2006/relationships" r:blip="">
                              <dgm:adjLst/>
                            </dgm:shape>
                            <dgm:presOf/>
                            <dgm:constrLst/>
                            <dgm:ruleLst/>
                            <dgm:forEach name="repeat" axis="ch">
                              <dgm:forEach name="Name22" axis="self" ptType="parTrans" cnt="1">
                                <dgm:layoutNode name="Name23">
                                  <dgm:choose name="Name24">
                                    <dgm:if name="Name25" axis="self" func="depth" op="lte" val="4">
                                      <dgm:alg type="conn">
                                        <dgm:param type="dim" val="1D"/>
                                        <dgm:param type="endSty" val="noArr"/>
                                        <dgm:param type="connRout" val="bend"/>
                                        <dgm:param type="bendPt" val="end"/>
                                        <dgm:param type="begPts" val="bCtr"/>
                                        <dgm:param type="endPts" val="tCtr"/>
                                        <dgm:param type="srcNode" val="background3"/>
                                        <dgm:param type="dstNode" val="background4"/>
                                      </dgm:alg>
                                    </dgm:if>
                                    <dgm:else name="Name26">
                                      <dgm:alg type="conn">
                                        <dgm:param type="dim" val="1D"/>
                                        <dgm:param type="endSty" val="noArr"/>
                                        <dgm:param type="connRout" val="bend"/>
                                        <dgm:param type="bendPt" val="end"/>
                                        <dgm:param type="begPts" val="bCtr"/>
                                        <dgm:param type="endPts" val="tCtr"/>
                                        <dgm:param type="srcNode" val="background4"/>
                                        <dgm:param type="dstNode" val="background4"/>
                                      </dgm:alg>
                                    </dgm:else>
                                  </dgm:choose>
                                  <dgm:shape xmlns:r="http://schemas.openxmlformats.org/officeDocument/2006/relationships" type="conn" r:blip="" zOrderOff="-999">
                                    <dgm:adjLst/>
                                  </dgm:shape>
                                  <dgm:presOf axis="self"/>
                                  <dgm:constrLst>
                                    <dgm:constr type="begPad"/>
                                    <dgm:constr type="endPad"/>
                                  </dgm:constrLst>
                                  <dgm:ruleLst/>
                                </dgm:layoutNode>
                              </dgm:forEach>
                              <dgm:forEach name="Name27" axis="self" ptType="node">
                                <dgm:layoutNode name="hierRoot4">
                                  <dgm:alg type="hierRoot"/>
                                  <dgm:shape xmlns:r="http://schemas.openxmlformats.org/officeDocument/2006/relationships" r:blip="">
                                    <dgm:adjLst/>
                                  </dgm:shape>
                                  <dgm:presOf/>
                                  <dgm:constrLst>
                                    <dgm:constr type="bendDist" for="des" ptType="parTrans" refType="sp" fact="0.5"/>
                                  </dgm:constrLst>
                                  <dgm:ruleLst/>
                                  <dgm:layoutNode name="composite4">
                                    <dgm:alg type="composite"/>
                                    <dgm:shape xmlns:r="http://schemas.openxmlformats.org/officeDocument/2006/relationships" r:blip="">
                                      <dgm:adjLst/>
                                    </dgm:shape>
                                    <dgm:presOf/>
                                    <dgm:constrLst>
                                      <dgm:constr type="w" for="ch" forName="background4" refType="w" fact="0.9"/>
                                      <dgm:constr type="h" for="ch" forName="background4" refType="w" refFor="ch" refForName="background4" fact="0.635"/>
                                      <dgm:constr type="t" for="ch" forName="background4"/>
                                      <dgm:constr type="l" for="ch" forName="background4"/>
                                      <dgm:constr type="w" for="ch" forName="text4" refType="w" fact="0.9"/>
                                      <dgm:constr type="h" for="ch" forName="text4" refType="w" refFor="ch" refForName="text4" fact="0.635"/>
                                      <dgm:constr type="t" for="ch" forName="text4" refType="w" fact="0.095"/>
                                      <dgm:constr type="l" for="ch" forName="text4" refType="w" fact="0.1"/>
                                    </dgm:constrLst>
                                    <dgm:ruleLst/>
                                    <dgm:layoutNode name="background4" moveWith="text4">
                                      <dgm:alg type="sp"/>
                                      <dgm:shape xmlns:r="http://schemas.openxmlformats.org/officeDocument/2006/relationships" type="roundRect" r:blip="">
                                        <dgm:adjLst>
                                          <dgm:adj idx="1" val="0.1"/>
                                        </dgm:adjLst>
                                      </dgm:shape>
                                      <dgm:presOf/>
                                      <dgm:constrLst/>
                                      <dgm:ruleLst/>
                                    </dgm:layoutNode>
                                    <dgm:layoutNode name="text4" styleLbl="fgAcc4">
                                      <dgm:varLst>
                                        <dgm:chPref val="3"/>
                                      </dgm:varLst>
                                      <dgm:alg type="tx"/>
                                      <dgm:shape xmlns:r="http://schemas.openxmlformats.org/officeDocument/2006/relationships" type="roundRect" r:blip="">
                                        <dgm:adjLst>
                                          <dgm:adj idx="1" val="0.1"/>
                                        </dgm:adjLst>
                                      </dgm:shape>
                                      <dgm:presOf axis="self"/>
                                      <dgm:constrLst>
                                        <dgm:constr type="tMarg" refType="primFontSz" fact="0.3"/>
                                        <dgm:constr type="bMarg" refType="primFontSz" fact="0.3"/>
                                        <dgm:constr type="lMarg" refType="primFontSz" fact="0.3"/>
                                        <dgm:constr type="rMarg" refType="primFontSz" fact="0.3"/>
                                      </dgm:constrLst>
                                      <dgm:ruleLst>
                                        <dgm:rule type="primFontSz" val="5" fact="NaN" max="NaN"/>
                                      </dgm:ruleLst>
                                    </dgm:layoutNode>
                                  </dgm:layoutNode>
                                  <dgm:layoutNode name="hierChild5">
                                    <dgm:choose name="Name28">
                                      <dgm:if name="Name29" func="var" arg="dir" op="equ" val="norm">
                                        <dgm:alg type="hierChild">
                                          <dgm:param type="linDir" val="fromL"/>
                                        </dgm:alg>
                                      </dgm:if>
                                      <dgm:else name="Name30">
                                        <dgm:alg type="hierChild">
                                          <dgm:param type="linDir" val="fromR"/>
                                        </dgm:alg>
                                      </dgm:else>
                                    </dgm:choose>
                                    <dgm:shape xmlns:r="http://schemas.openxmlformats.org/officeDocument/2006/relationships" r:blip="">
                                      <dgm:adjLst/>
                                    </dgm:shape>
                                    <dgm:presOf/>
                                    <dgm:constrLst/>
                                    <dgm:ruleLst/>
                                    <dgm:forEach name="Name31" ref="repeat"/>
                                  </dgm:layoutNode>
                                </dgm:layoutNode>
                              </dgm:forEach>
                            </dgm:forEach>
                          </dgm:layoutNode>
                        </dgm:layoutNode>
                      </dgm:forEach>
                    </dgm:forEach>
                  </dgm:layoutNode>
                </dgm:layoutNode>
              </dgm:forEach>
            </dgm:forEach>
          </dgm:layoutNode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D309CDF-1558-1948-A35B-90EAD1CC5E36}" type="datetimeFigureOut">
              <a:rPr lang="en-US" smtClean="0"/>
              <a:t>1/2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7028050-2119-9D4C-B7E2-C2A26E30C5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39752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7028050-2119-9D4C-B7E2-C2A26E30C5B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570272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4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7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5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9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1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3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E3E836C-C2CF-414B-BCA5-FE861C8D1262}" type="datetimeFigureOut">
              <a:rPr lang="en-US"/>
              <a:pPr>
                <a:defRPr/>
              </a:pPr>
              <a:t>1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93B7E3E-DB1E-459B-8616-98F1B7372BAB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178905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2F4658-D6F5-40BD-9F8C-77EF04783B7F}" type="datetimeFigureOut">
              <a:rPr lang="en-US"/>
              <a:pPr>
                <a:defRPr/>
              </a:pPr>
              <a:t>1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BA1B6D6-B2ED-4DBC-9085-CCC01E204C8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1240622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8" y="488953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488953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1FE5320-E11A-4FFA-A48B-C7C323C0716E}" type="datetimeFigureOut">
              <a:rPr lang="en-US"/>
              <a:pPr>
                <a:defRPr/>
              </a:pPr>
              <a:t>1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320C24C-34DC-4B6C-9639-FDE6DB9BC65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488083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8CE3027-6451-4573-843A-D40D0C944796}" type="datetimeFigureOut">
              <a:rPr lang="en-US"/>
              <a:pPr>
                <a:defRPr/>
              </a:pPr>
              <a:t>1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8A8874E-8C86-4547-92FB-664E16B96CD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640104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9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5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89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37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13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A4241B9-712B-4562-83DD-EDB39C627109}" type="datetimeFigureOut">
              <a:rPr lang="en-US"/>
              <a:pPr>
                <a:defRPr/>
              </a:pPr>
              <a:t>1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54EA89E-3B20-49A6-B3E9-157BB0E8FDD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5416240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40048B1-8D34-46AD-955E-2CC5960DDD8A}" type="datetimeFigureOut">
              <a:rPr lang="en-US"/>
              <a:pPr>
                <a:defRPr/>
              </a:pPr>
              <a:t>1/2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95495FC-4C92-427F-AB90-4096AC32CCE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986810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3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3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3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3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507A347-9910-430E-963C-4DFDFC8F85AF}" type="datetimeFigureOut">
              <a:rPr lang="en-US"/>
              <a:pPr>
                <a:defRPr/>
              </a:pPr>
              <a:t>1/2/20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66A0F90-771E-46D9-8ECA-76B0EB490F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899472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AD9220-B3EF-4892-B3AF-211E0AEFF284}" type="datetimeFigureOut">
              <a:rPr lang="en-US"/>
              <a:pPr>
                <a:defRPr/>
              </a:pPr>
              <a:t>1/2/20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A559672-5932-4AA4-987B-556698E276B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5348705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2505FCB-8FA1-4321-A833-C244F2CA8B40}" type="datetimeFigureOut">
              <a:rPr lang="en-US"/>
              <a:pPr>
                <a:defRPr/>
              </a:pPr>
              <a:t>1/2/20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DB59822-0391-4C8C-9D43-C2870CC70B3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5769673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4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1" y="364074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4" y="1913473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7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1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8A4CAE-3347-4CF6-B2A0-0CB4416CAAB1}" type="datetimeFigureOut">
              <a:rPr lang="en-US"/>
              <a:pPr>
                <a:defRPr/>
              </a:pPr>
              <a:t>1/2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9658EB0-57D7-442C-80D9-BD8EF75D1CC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841725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7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1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7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1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88F2BDF-C206-4DDC-89C6-0FF2DCAA1A7E}" type="datetimeFigureOut">
              <a:rPr lang="en-US"/>
              <a:pPr>
                <a:defRPr/>
              </a:pPr>
              <a:t>1/2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F1B9028-8BBC-4AAD-B89A-BD29D46E115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648294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666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prstClr val="black">
                    <a:tint val="75000"/>
                  </a:prst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2AE53097-FBAF-4D24-AACE-BCF21938F6C4}" type="datetimeFigureOut">
              <a:rPr lang="en-US"/>
              <a:pPr>
                <a:defRPr/>
              </a:pPr>
              <a:t>1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666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prstClr val="black">
                    <a:tint val="75000"/>
                  </a:prst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666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solidFill>
                  <a:srgbClr val="898989"/>
                </a:solidFill>
                <a:latin typeface="Calibri" panose="020F0502020204030204" pitchFamily="34" charset="0"/>
              </a:defRPr>
            </a:lvl1pPr>
          </a:lstStyle>
          <a:p>
            <a:pPr>
              <a:defRPr/>
            </a:pPr>
            <a:fld id="{55F0FCB0-A81C-450A-828C-7421542915B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9250344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189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377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566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754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891" indent="-342891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32" indent="-285744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1" indent="-228594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9" indent="-228594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4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7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1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1.xml"/><Relationship Id="rId7" Type="http://schemas.microsoft.com/office/2007/relationships/diagramDrawing" Target="../diagrams/drawing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diagramColors" Target="../diagrams/colors1.xml"/><Relationship Id="rId5" Type="http://schemas.openxmlformats.org/officeDocument/2006/relationships/diagramQuickStyle" Target="../diagrams/quickStyle1.xml"/><Relationship Id="rId4" Type="http://schemas.openxmlformats.org/officeDocument/2006/relationships/diagramLayout" Target="../diagrams/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Diagram 3">
            <a:extLst>
              <a:ext uri="{FF2B5EF4-FFF2-40B4-BE49-F238E27FC236}">
                <a16:creationId xmlns:a16="http://schemas.microsoft.com/office/drawing/2014/main" xmlns="" id="{088FAC87-787D-C64D-B132-9E188228F534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444560918"/>
              </p:ext>
            </p:extLst>
          </p:nvPr>
        </p:nvGraphicFramePr>
        <p:xfrm>
          <a:off x="292608" y="444501"/>
          <a:ext cx="6352741" cy="4939541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  <p:sp>
        <p:nvSpPr>
          <p:cNvPr id="5" name="TextBox 2">
            <a:extLst>
              <a:ext uri="{FF2B5EF4-FFF2-40B4-BE49-F238E27FC236}">
                <a16:creationId xmlns:a16="http://schemas.microsoft.com/office/drawing/2014/main" xmlns="" id="{F29822A3-A6BA-4D43-B49A-3E81361D4DE1}"/>
              </a:ext>
            </a:extLst>
          </p:cNvPr>
          <p:cNvSpPr txBox="1"/>
          <p:nvPr/>
        </p:nvSpPr>
        <p:spPr>
          <a:xfrm>
            <a:off x="292608" y="5018558"/>
            <a:ext cx="6352741" cy="461665"/>
          </a:xfrm>
          <a:prstGeom prst="rect">
            <a:avLst/>
          </a:prstGeom>
          <a:solidFill>
            <a:schemeClr val="bg1"/>
          </a:solidFill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ctr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sz="12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3. </a:t>
            </a:r>
            <a:r>
              <a:rPr lang="en-US" sz="1200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erarchica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rganization of all 11 GO terms enriched in both STm up- and down-regulated gene datasets.</a:t>
            </a:r>
          </a:p>
        </p:txBody>
      </p:sp>
    </p:spTree>
    <p:extLst>
      <p:ext uri="{BB962C8B-B14F-4D97-AF65-F5344CB8AC3E}">
        <p14:creationId xmlns:p14="http://schemas.microsoft.com/office/powerpoint/2010/main" val="2740502227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942</TotalTime>
  <Words>63</Words>
  <Application>Microsoft Office PowerPoint</Application>
  <PresentationFormat>Letter Paper (8.5x11 in)</PresentationFormat>
  <Paragraphs>1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1_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ula Rodrigues Oblessuc</dc:creator>
  <cp:lastModifiedBy>JOLANO</cp:lastModifiedBy>
  <cp:revision>94</cp:revision>
  <dcterms:created xsi:type="dcterms:W3CDTF">2018-06-21T22:55:33Z</dcterms:created>
  <dcterms:modified xsi:type="dcterms:W3CDTF">2020-01-02T15:51:47Z</dcterms:modified>
</cp:coreProperties>
</file>